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99" r:id="rId2"/>
    <p:sldId id="304" r:id="rId3"/>
    <p:sldId id="300" r:id="rId4"/>
    <p:sldId id="302" r:id="rId5"/>
    <p:sldId id="5869" r:id="rId6"/>
    <p:sldId id="5870" r:id="rId7"/>
    <p:sldId id="5871" r:id="rId8"/>
    <p:sldId id="5872" r:id="rId9"/>
    <p:sldId id="5873" r:id="rId10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3" autoAdjust="0"/>
    <p:restoredTop sz="94660"/>
  </p:normalViewPr>
  <p:slideViewPr>
    <p:cSldViewPr snapToGrid="0">
      <p:cViewPr varScale="1">
        <p:scale>
          <a:sx n="79" d="100"/>
          <a:sy n="79" d="100"/>
        </p:scale>
        <p:origin x="811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6DE04C-174C-4D6E-ADB9-8EFA1F34ADFA}" type="datetimeFigureOut">
              <a:rPr lang="ko-KR" altLang="en-US" smtClean="0"/>
              <a:t>2025-12-2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3B2416-B64B-4710-A029-78B0BB70D76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9439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B01CB9-4557-45A4-AF7D-01B819E0A0DA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66994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B01CB9-4557-45A4-AF7D-01B819E0A0DA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9273298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4755534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D3B2416-B64B-4710-A029-78B0BB70D766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862799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055694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2F46E64-0C6C-4450-A182-82082C20C6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139732CE-6AA6-4582-B4AA-946679D453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6F7BBC4-9797-478F-8FCE-B218AB3E1B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7C34A-E56B-408C-98F4-F27457930266}" type="datetimeFigureOut">
              <a:rPr lang="ko-KR" altLang="en-US" smtClean="0"/>
              <a:t>2025-12-2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C767A00-DCCB-48F0-BDA8-6830BE8D31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ABF5E33-F201-42D2-938C-95D45BFD37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EDC13-77F4-4ADC-B55B-EF299285C3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8811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57FF48C-D93A-4626-BD6B-F501FDCBB8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9E76C88-7D03-45AE-B535-AE84C0F94F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4D11753-4EDC-4405-80A1-BD47E26C58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7C34A-E56B-408C-98F4-F27457930266}" type="datetimeFigureOut">
              <a:rPr lang="ko-KR" altLang="en-US" smtClean="0"/>
              <a:t>2025-12-2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400E8EB-D8A5-4755-873D-A466DB66B7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669619D-D348-43A9-B97B-0DF011A8E8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EDC13-77F4-4ADC-B55B-EF299285C3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4551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1A3B403C-49F2-4991-BF66-534D1D3759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DA8F57F7-9F3E-445D-831F-1488E06170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F3F35F8-0FDB-4F97-80B9-5EAC474179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7C34A-E56B-408C-98F4-F27457930266}" type="datetimeFigureOut">
              <a:rPr lang="ko-KR" altLang="en-US" smtClean="0"/>
              <a:t>2025-12-2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8EF8766-C865-4689-814F-64636B4307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3D9FC34-7415-4CEE-9745-26793E3744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EDC13-77F4-4ADC-B55B-EF299285C3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2028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F27486E-DE41-45B7-BFBB-04A446AEC8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CFB1177-EF7F-478C-B018-5A3182E400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BA65F34-AA50-48B8-9BDD-CDB46BE374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7C34A-E56B-408C-98F4-F27457930266}" type="datetimeFigureOut">
              <a:rPr lang="ko-KR" altLang="en-US" smtClean="0"/>
              <a:t>2025-12-2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2188E53-C96D-4EC8-B1A2-5AA23720DD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6F190C6-F548-45E8-B639-D10EB1B866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EDC13-77F4-4ADC-B55B-EF299285C3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2905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69F3D79-84BA-4135-8AFD-4B270D3D54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2A250DC-F153-4B92-B9B6-6E4E74D7F0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32CC070-B44A-4497-8ADE-D99761423E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7C34A-E56B-408C-98F4-F27457930266}" type="datetimeFigureOut">
              <a:rPr lang="ko-KR" altLang="en-US" smtClean="0"/>
              <a:t>2025-12-2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FFA3151-5347-461D-901B-158A0688E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2411519-5EF3-4E42-88AF-63381920F4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EDC13-77F4-4ADC-B55B-EF299285C3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2966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7B980F0-C3FC-4F64-B7C7-05A3BCE46A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19BD4DF-C566-4FB4-BA47-A83A71AF8AC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5475C25-23FE-47D9-8C36-EC4FA77105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8D6BDF3-FBD0-498E-8ADB-699F225CD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7C34A-E56B-408C-98F4-F27457930266}" type="datetimeFigureOut">
              <a:rPr lang="ko-KR" altLang="en-US" smtClean="0"/>
              <a:t>2025-12-2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5A34933-0651-4961-ABA0-66392AC954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1E7D526-483F-4BEE-8AC8-CE0F0A2E6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EDC13-77F4-4ADC-B55B-EF299285C3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9199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6E176F9-99DA-49D5-A5B6-B0348B66D5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A9AB7B7-6372-4DD6-89D8-A441F2B628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42FBAB4-FAD0-4C3A-B93D-8C203475F2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EE214912-63CA-4CE7-9E32-EE5BAF417B0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7BDFF9EE-B8C4-443E-9A19-259B182BD6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660F7169-5B11-40D8-BC27-D4BABFFF6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7C34A-E56B-408C-98F4-F27457930266}" type="datetimeFigureOut">
              <a:rPr lang="ko-KR" altLang="en-US" smtClean="0"/>
              <a:t>2025-12-2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7902EF0D-9EB8-47E5-B6C1-0954424F52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9B0907F-F8D4-4872-88F2-4F3A27F696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EDC13-77F4-4ADC-B55B-EF299285C3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3724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FB5EE79-2403-41D6-897F-8A22E1607B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59AEC793-807D-4FF4-B90C-4F462BF94D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7C34A-E56B-408C-98F4-F27457930266}" type="datetimeFigureOut">
              <a:rPr lang="ko-KR" altLang="en-US" smtClean="0"/>
              <a:t>2025-12-2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B0A35E9-E2B0-444B-A76C-B7992CDF60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ED4A046B-2B46-4D46-8130-62A800C87D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EDC13-77F4-4ADC-B55B-EF299285C3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7818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E530199F-8CB7-4154-AE6F-ACDC7399F7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7C34A-E56B-408C-98F4-F27457930266}" type="datetimeFigureOut">
              <a:rPr lang="ko-KR" altLang="en-US" smtClean="0"/>
              <a:t>2025-12-2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4AA4A980-DD93-483E-9995-0188E677F2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8225E394-2F76-4DB6-9F4F-0A0C019832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EDC13-77F4-4ADC-B55B-EF299285C3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75055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F0DA0B1-DD81-4B7D-8A8C-9DBD0F0EB5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8845916-3FA0-4A59-AA58-DA1EC29DD5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9534593-7641-4E31-BCDD-9DF03EDB6F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FFE3C01-F210-4C62-AC93-8E5A9E9077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7C34A-E56B-408C-98F4-F27457930266}" type="datetimeFigureOut">
              <a:rPr lang="ko-KR" altLang="en-US" smtClean="0"/>
              <a:t>2025-12-2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E68BACD-E571-4C14-BB40-14CE4F1DC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DF77A6D-0DDF-43F2-B0D9-EBF29FEAD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EDC13-77F4-4ADC-B55B-EF299285C3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521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444A0DA-FC9C-4E81-99F9-833002C565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BE50623C-F1C5-40BE-BDA2-A08809FDA4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1C1A523-D06D-49C9-AE03-61E21E335A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8DBDDCA-CB8F-474F-AFB1-8534A5D636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7C34A-E56B-408C-98F4-F27457930266}" type="datetimeFigureOut">
              <a:rPr lang="ko-KR" altLang="en-US" smtClean="0"/>
              <a:t>2025-12-2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831726F-17F7-4D8D-B1AD-850E111D55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449BEF3-404E-40EE-AA42-80BFEEAA86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EDC13-77F4-4ADC-B55B-EF299285C3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88834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7B1D35BC-AF1E-4B6A-A7A5-F065EF1892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C3687CD-F0D2-41B6-BAB7-E7F34899E9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F1F29C6-C1FA-4D56-BCB9-AEE1D3A24F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37C34A-E56B-408C-98F4-F27457930266}" type="datetimeFigureOut">
              <a:rPr lang="ko-KR" altLang="en-US" smtClean="0"/>
              <a:t>2025-12-2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643C048-F6E3-4ACC-B9CD-6BB133FDD9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2417A89-C42F-4B62-B9C0-86238E3FF5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9EDC13-77F4-4ADC-B55B-EF299285C3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3361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sv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5.svg"/><Relationship Id="rId4" Type="http://schemas.openxmlformats.org/officeDocument/2006/relationships/image" Target="../media/image2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sv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9.svg"/><Relationship Id="rId4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0F9A7A5-0140-4367-B453-27D1C654430A}"/>
              </a:ext>
            </a:extLst>
          </p:cNvPr>
          <p:cNvSpPr txBox="1"/>
          <p:nvPr/>
        </p:nvSpPr>
        <p:spPr>
          <a:xfrm>
            <a:off x="298450" y="257522"/>
            <a:ext cx="17300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sz="2000" b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ko-KR" altLang="en-US" sz="20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S1A</a:t>
            </a:r>
            <a:endParaRPr kumimoji="1" lang="ko-Kore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직선 연결선 4">
            <a:extLst>
              <a:ext uri="{FF2B5EF4-FFF2-40B4-BE49-F238E27FC236}">
                <a16:creationId xmlns:a16="http://schemas.microsoft.com/office/drawing/2014/main" id="{8C6145B8-510D-458A-82E1-05441366D9FB}"/>
              </a:ext>
            </a:extLst>
          </p:cNvPr>
          <p:cNvCxnSpPr>
            <a:cxnSpLocks/>
          </p:cNvCxnSpPr>
          <p:nvPr/>
        </p:nvCxnSpPr>
        <p:spPr>
          <a:xfrm>
            <a:off x="2870254" y="3437894"/>
            <a:ext cx="12859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직선 화살표 연결선 5">
            <a:extLst>
              <a:ext uri="{FF2B5EF4-FFF2-40B4-BE49-F238E27FC236}">
                <a16:creationId xmlns:a16="http://schemas.microsoft.com/office/drawing/2014/main" id="{FC5E63DC-266F-4331-A726-D63F1277C6A1}"/>
              </a:ext>
            </a:extLst>
          </p:cNvPr>
          <p:cNvCxnSpPr>
            <a:cxnSpLocks/>
          </p:cNvCxnSpPr>
          <p:nvPr/>
        </p:nvCxnSpPr>
        <p:spPr>
          <a:xfrm>
            <a:off x="298450" y="5083060"/>
            <a:ext cx="11334750" cy="950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직선 화살표 연결선 6">
            <a:extLst>
              <a:ext uri="{FF2B5EF4-FFF2-40B4-BE49-F238E27FC236}">
                <a16:creationId xmlns:a16="http://schemas.microsoft.com/office/drawing/2014/main" id="{E159BB0D-F797-40FC-9314-4008F0B4D9D8}"/>
              </a:ext>
            </a:extLst>
          </p:cNvPr>
          <p:cNvCxnSpPr/>
          <p:nvPr/>
        </p:nvCxnSpPr>
        <p:spPr>
          <a:xfrm flipV="1">
            <a:off x="2870254" y="1498197"/>
            <a:ext cx="0" cy="358486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AED24C36-7C85-407D-B5B2-FF65B6ED9D07}"/>
              </a:ext>
            </a:extLst>
          </p:cNvPr>
          <p:cNvSpPr txBox="1"/>
          <p:nvPr/>
        </p:nvSpPr>
        <p:spPr>
          <a:xfrm>
            <a:off x="2615753" y="1151159"/>
            <a:ext cx="11014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ent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D8CECE8-EE68-4563-A9C5-6D8BEA36FC40}"/>
              </a:ext>
            </a:extLst>
          </p:cNvPr>
          <p:cNvSpPr txBox="1"/>
          <p:nvPr/>
        </p:nvSpPr>
        <p:spPr>
          <a:xfrm>
            <a:off x="2195846" y="5157444"/>
            <a:ext cx="16639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sit S</a:t>
            </a:r>
          </a:p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reening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직선 화살표 연결선 10">
            <a:extLst>
              <a:ext uri="{FF2B5EF4-FFF2-40B4-BE49-F238E27FC236}">
                <a16:creationId xmlns:a16="http://schemas.microsoft.com/office/drawing/2014/main" id="{93AE8512-23F3-4944-9FA2-E5B38C4F4EC3}"/>
              </a:ext>
            </a:extLst>
          </p:cNvPr>
          <p:cNvCxnSpPr>
            <a:cxnSpLocks/>
          </p:cNvCxnSpPr>
          <p:nvPr/>
        </p:nvCxnSpPr>
        <p:spPr>
          <a:xfrm flipV="1">
            <a:off x="4128491" y="1513827"/>
            <a:ext cx="0" cy="356923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9EFBA8CF-84D8-47FB-A9DF-63350C4519FE}"/>
              </a:ext>
            </a:extLst>
          </p:cNvPr>
          <p:cNvSpPr txBox="1"/>
          <p:nvPr/>
        </p:nvSpPr>
        <p:spPr>
          <a:xfrm>
            <a:off x="3535335" y="1151158"/>
            <a:ext cx="19119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ndomization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11C2338-ED1B-4696-AAE7-4495A790086C}"/>
              </a:ext>
            </a:extLst>
          </p:cNvPr>
          <p:cNvSpPr txBox="1"/>
          <p:nvPr/>
        </p:nvSpPr>
        <p:spPr>
          <a:xfrm>
            <a:off x="3518687" y="5150395"/>
            <a:ext cx="12988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sit 1</a:t>
            </a:r>
          </a:p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week 0)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D553258-4A46-4648-A3B6-97FE2AC074B5}"/>
              </a:ext>
            </a:extLst>
          </p:cNvPr>
          <p:cNvSpPr txBox="1"/>
          <p:nvPr/>
        </p:nvSpPr>
        <p:spPr>
          <a:xfrm>
            <a:off x="5447256" y="5131342"/>
            <a:ext cx="12988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sit 2</a:t>
            </a:r>
          </a:p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week 4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F8C4D11-4F0C-4D3D-89B7-9EB9E8967637}"/>
              </a:ext>
            </a:extLst>
          </p:cNvPr>
          <p:cNvSpPr txBox="1"/>
          <p:nvPr/>
        </p:nvSpPr>
        <p:spPr>
          <a:xfrm>
            <a:off x="8002228" y="5134327"/>
            <a:ext cx="12988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sit 3</a:t>
            </a:r>
          </a:p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week 12)</a:t>
            </a:r>
          </a:p>
        </p:txBody>
      </p: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3A37034F-1591-458F-B278-9B29249201F2}"/>
              </a:ext>
            </a:extLst>
          </p:cNvPr>
          <p:cNvCxnSpPr>
            <a:cxnSpLocks/>
            <a:endCxn id="24" idx="1"/>
          </p:cNvCxnSpPr>
          <p:nvPr/>
        </p:nvCxnSpPr>
        <p:spPr>
          <a:xfrm flipV="1">
            <a:off x="4160519" y="2776734"/>
            <a:ext cx="481822" cy="65226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id="{16A9F6D1-90D7-41DF-A331-C68104CEB230}"/>
              </a:ext>
            </a:extLst>
          </p:cNvPr>
          <p:cNvCxnSpPr>
            <a:cxnSpLocks/>
            <a:endCxn id="56" idx="1"/>
          </p:cNvCxnSpPr>
          <p:nvPr/>
        </p:nvCxnSpPr>
        <p:spPr>
          <a:xfrm>
            <a:off x="4160519" y="3428998"/>
            <a:ext cx="492553" cy="76226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F63DFD86-388C-4C97-B1B9-D089063A60D0}"/>
              </a:ext>
            </a:extLst>
          </p:cNvPr>
          <p:cNvSpPr txBox="1"/>
          <p:nvPr/>
        </p:nvSpPr>
        <p:spPr>
          <a:xfrm>
            <a:off x="4642341" y="2515124"/>
            <a:ext cx="1453660" cy="52322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laglutide</a:t>
            </a:r>
          </a:p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5 mg </a:t>
            </a:r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B2D0B67-FE90-44EE-85BB-B00C0E5B8CEC}"/>
              </a:ext>
            </a:extLst>
          </p:cNvPr>
          <p:cNvSpPr txBox="1"/>
          <p:nvPr/>
        </p:nvSpPr>
        <p:spPr>
          <a:xfrm>
            <a:off x="4156217" y="1661298"/>
            <a:ext cx="4590958" cy="307777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pen-label treatment period  </a:t>
            </a:r>
            <a:endParaRPr lang="ko-KR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26EC06C-EB7C-4368-8279-5A993D207EF4}"/>
              </a:ext>
            </a:extLst>
          </p:cNvPr>
          <p:cNvSpPr txBox="1"/>
          <p:nvPr/>
        </p:nvSpPr>
        <p:spPr>
          <a:xfrm>
            <a:off x="298451" y="2871153"/>
            <a:ext cx="2555790" cy="111569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</a:t>
            </a:r>
            <a:r>
              <a:rPr lang="en-US" altLang="ko-KR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T2DM</a:t>
            </a:r>
          </a:p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controlled with  </a:t>
            </a:r>
          </a:p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imepiride ≥4mg/d + Metformin≥1000mg/d</a:t>
            </a:r>
          </a:p>
          <a:p>
            <a:pPr algn="ctr"/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7.0%≤HbA1c)</a:t>
            </a:r>
          </a:p>
        </p:txBody>
      </p:sp>
      <p:cxnSp>
        <p:nvCxnSpPr>
          <p:cNvPr id="40" name="직선 화살표 연결선 39">
            <a:extLst>
              <a:ext uri="{FF2B5EF4-FFF2-40B4-BE49-F238E27FC236}">
                <a16:creationId xmlns:a16="http://schemas.microsoft.com/office/drawing/2014/main" id="{33608609-D157-48B1-AD5E-C68D0A6B9116}"/>
              </a:ext>
            </a:extLst>
          </p:cNvPr>
          <p:cNvCxnSpPr>
            <a:cxnSpLocks/>
          </p:cNvCxnSpPr>
          <p:nvPr/>
        </p:nvCxnSpPr>
        <p:spPr>
          <a:xfrm flipV="1">
            <a:off x="8763245" y="1523335"/>
            <a:ext cx="0" cy="356923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AED0AC75-204A-4E82-9952-0389E35E29B8}"/>
              </a:ext>
            </a:extLst>
          </p:cNvPr>
          <p:cNvSpPr txBox="1"/>
          <p:nvPr/>
        </p:nvSpPr>
        <p:spPr>
          <a:xfrm>
            <a:off x="7726819" y="1181854"/>
            <a:ext cx="19119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d of trial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직사각형 47">
            <a:extLst>
              <a:ext uri="{FF2B5EF4-FFF2-40B4-BE49-F238E27FC236}">
                <a16:creationId xmlns:a16="http://schemas.microsoft.com/office/drawing/2014/main" id="{F887B93A-E543-4986-9A01-BC401B70F0BA}"/>
              </a:ext>
            </a:extLst>
          </p:cNvPr>
          <p:cNvSpPr/>
          <p:nvPr/>
        </p:nvSpPr>
        <p:spPr>
          <a:xfrm>
            <a:off x="3783499" y="5596671"/>
            <a:ext cx="82426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seline</a:t>
            </a:r>
          </a:p>
        </p:txBody>
      </p:sp>
      <p:sp>
        <p:nvSpPr>
          <p:cNvPr id="49" name="직사각형 48">
            <a:extLst>
              <a:ext uri="{FF2B5EF4-FFF2-40B4-BE49-F238E27FC236}">
                <a16:creationId xmlns:a16="http://schemas.microsoft.com/office/drawing/2014/main" id="{AA962DEF-ED57-4FF9-833A-A8FB1BEC88AA}"/>
              </a:ext>
            </a:extLst>
          </p:cNvPr>
          <p:cNvSpPr/>
          <p:nvPr/>
        </p:nvSpPr>
        <p:spPr>
          <a:xfrm>
            <a:off x="8115612" y="5590728"/>
            <a:ext cx="107112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d of trial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A947C67-7D6A-42D8-908E-DDD2F55A626E}"/>
              </a:ext>
            </a:extLst>
          </p:cNvPr>
          <p:cNvSpPr txBox="1"/>
          <p:nvPr/>
        </p:nvSpPr>
        <p:spPr>
          <a:xfrm>
            <a:off x="6096000" y="2515123"/>
            <a:ext cx="2683316" cy="523220"/>
          </a:xfrm>
          <a:prstGeom prst="rect">
            <a:avLst/>
          </a:prstGeom>
          <a:solidFill>
            <a:srgbClr val="FF0000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ulaglutide</a:t>
            </a:r>
          </a:p>
          <a:p>
            <a:pPr algn="ctr"/>
            <a:r>
              <a:rPr lang="en-US" altLang="ko-KR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.5 mg </a:t>
            </a:r>
            <a:r>
              <a:rPr lang="en-US" altLang="ko-KR" sz="1400" b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</a:t>
            </a:r>
            <a:r>
              <a:rPr lang="en-US" altLang="ko-KR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ko-KR" sz="1400" b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endParaRPr lang="ko-KR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F867226-7122-4321-860D-A9EE7801A13B}"/>
              </a:ext>
            </a:extLst>
          </p:cNvPr>
          <p:cNvSpPr txBox="1"/>
          <p:nvPr/>
        </p:nvSpPr>
        <p:spPr>
          <a:xfrm>
            <a:off x="4653072" y="3929657"/>
            <a:ext cx="1453660" cy="523220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pagliflozin </a:t>
            </a:r>
          </a:p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mg/d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4658ED9-DFC5-42D3-B09E-73A3FD0312AC}"/>
              </a:ext>
            </a:extLst>
          </p:cNvPr>
          <p:cNvSpPr txBox="1"/>
          <p:nvPr/>
        </p:nvSpPr>
        <p:spPr>
          <a:xfrm>
            <a:off x="6106732" y="3929656"/>
            <a:ext cx="2651392" cy="523220"/>
          </a:xfrm>
          <a:prstGeom prst="rect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pagliflozin</a:t>
            </a:r>
          </a:p>
          <a:p>
            <a:pPr algn="ctr"/>
            <a:r>
              <a:rPr lang="en-US" altLang="ko-KR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 mg/d</a:t>
            </a:r>
            <a:endParaRPr lang="ko-KR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화살표: 오른쪽 1">
            <a:extLst>
              <a:ext uri="{FF2B5EF4-FFF2-40B4-BE49-F238E27FC236}">
                <a16:creationId xmlns:a16="http://schemas.microsoft.com/office/drawing/2014/main" id="{0BFC94BC-9EAF-4D25-A411-DADACE6CDED9}"/>
              </a:ext>
            </a:extLst>
          </p:cNvPr>
          <p:cNvSpPr/>
          <p:nvPr/>
        </p:nvSpPr>
        <p:spPr>
          <a:xfrm>
            <a:off x="8779316" y="2538068"/>
            <a:ext cx="2359590" cy="47733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화살표: 오른쪽 26">
            <a:extLst>
              <a:ext uri="{FF2B5EF4-FFF2-40B4-BE49-F238E27FC236}">
                <a16:creationId xmlns:a16="http://schemas.microsoft.com/office/drawing/2014/main" id="{53A887C8-557A-41FE-A64B-A1E5D22C9183}"/>
              </a:ext>
            </a:extLst>
          </p:cNvPr>
          <p:cNvSpPr/>
          <p:nvPr/>
        </p:nvSpPr>
        <p:spPr>
          <a:xfrm>
            <a:off x="8763245" y="3952601"/>
            <a:ext cx="2370538" cy="477330"/>
          </a:xfrm>
          <a:prstGeom prst="rightArrow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30" name="직선 화살표 연결선 29">
            <a:extLst>
              <a:ext uri="{FF2B5EF4-FFF2-40B4-BE49-F238E27FC236}">
                <a16:creationId xmlns:a16="http://schemas.microsoft.com/office/drawing/2014/main" id="{8589742B-D5F5-44E6-97F8-DA40797C8BCC}"/>
              </a:ext>
            </a:extLst>
          </p:cNvPr>
          <p:cNvCxnSpPr>
            <a:cxnSpLocks/>
          </p:cNvCxnSpPr>
          <p:nvPr/>
        </p:nvCxnSpPr>
        <p:spPr>
          <a:xfrm flipV="1">
            <a:off x="11133784" y="1489712"/>
            <a:ext cx="0" cy="356923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C31E4FE8-50CA-490A-81F4-4126A400DD32}"/>
              </a:ext>
            </a:extLst>
          </p:cNvPr>
          <p:cNvSpPr txBox="1"/>
          <p:nvPr/>
        </p:nvSpPr>
        <p:spPr>
          <a:xfrm>
            <a:off x="10338880" y="5131342"/>
            <a:ext cx="14162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sit 5</a:t>
            </a:r>
          </a:p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week 36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6FBDF20-0ABF-43A0-AF51-5862ADBD1239}"/>
              </a:ext>
            </a:extLst>
          </p:cNvPr>
          <p:cNvSpPr txBox="1"/>
          <p:nvPr/>
        </p:nvSpPr>
        <p:spPr>
          <a:xfrm>
            <a:off x="8790969" y="1654579"/>
            <a:ext cx="2337694" cy="307777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st-trial extension period</a:t>
            </a:r>
            <a:endParaRPr lang="ko-KR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7F77EF9-2B0E-4817-A905-3F5DAFDEA849}"/>
              </a:ext>
            </a:extLst>
          </p:cNvPr>
          <p:cNvSpPr txBox="1"/>
          <p:nvPr/>
        </p:nvSpPr>
        <p:spPr>
          <a:xfrm>
            <a:off x="10091039" y="1203206"/>
            <a:ext cx="19119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d of study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D671504-18BF-4B90-8854-3792C4CA560A}"/>
              </a:ext>
            </a:extLst>
          </p:cNvPr>
          <p:cNvSpPr txBox="1"/>
          <p:nvPr/>
        </p:nvSpPr>
        <p:spPr>
          <a:xfrm>
            <a:off x="9346722" y="5131342"/>
            <a:ext cx="12988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sit 4</a:t>
            </a:r>
          </a:p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week 24)</a:t>
            </a:r>
          </a:p>
        </p:txBody>
      </p:sp>
    </p:spTree>
    <p:extLst>
      <p:ext uri="{BB962C8B-B14F-4D97-AF65-F5344CB8AC3E}">
        <p14:creationId xmlns:p14="http://schemas.microsoft.com/office/powerpoint/2010/main" val="19280006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2177E5C-91A4-4F6F-A3B6-8CAB1A6882F1}"/>
              </a:ext>
            </a:extLst>
          </p:cNvPr>
          <p:cNvSpPr txBox="1"/>
          <p:nvPr/>
        </p:nvSpPr>
        <p:spPr>
          <a:xfrm>
            <a:off x="142879" y="207813"/>
            <a:ext cx="17300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sz="2000" b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ko-KR" altLang="en-US" sz="20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S1B</a:t>
            </a:r>
            <a:r>
              <a:rPr kumimoji="1" lang="ko-KR" altLang="en-US" sz="20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ko-Kore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7" name="그룹 56">
            <a:extLst>
              <a:ext uri="{FF2B5EF4-FFF2-40B4-BE49-F238E27FC236}">
                <a16:creationId xmlns:a16="http://schemas.microsoft.com/office/drawing/2014/main" id="{1A412AAB-7E1B-4409-AA86-FC257E513389}"/>
              </a:ext>
            </a:extLst>
          </p:cNvPr>
          <p:cNvGrpSpPr/>
          <p:nvPr/>
        </p:nvGrpSpPr>
        <p:grpSpPr>
          <a:xfrm>
            <a:off x="1029970" y="430430"/>
            <a:ext cx="10968989" cy="6032888"/>
            <a:chOff x="196850" y="412556"/>
            <a:chExt cx="10968989" cy="6032888"/>
          </a:xfrm>
        </p:grpSpPr>
        <p:cxnSp>
          <p:nvCxnSpPr>
            <p:cNvPr id="25" name="직선 연결선 24">
              <a:extLst>
                <a:ext uri="{FF2B5EF4-FFF2-40B4-BE49-F238E27FC236}">
                  <a16:creationId xmlns:a16="http://schemas.microsoft.com/office/drawing/2014/main" id="{F3B41772-E06E-42FE-9F9B-EF4023A683D5}"/>
                </a:ext>
              </a:extLst>
            </p:cNvPr>
            <p:cNvCxnSpPr>
              <a:cxnSpLocks/>
            </p:cNvCxnSpPr>
            <p:nvPr/>
          </p:nvCxnSpPr>
          <p:spPr>
            <a:xfrm>
              <a:off x="2642870" y="3062246"/>
              <a:ext cx="511556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56" name="그룹 55">
              <a:extLst>
                <a:ext uri="{FF2B5EF4-FFF2-40B4-BE49-F238E27FC236}">
                  <a16:creationId xmlns:a16="http://schemas.microsoft.com/office/drawing/2014/main" id="{CBE3B307-CED2-400F-AD25-B7CAFB8D2DAA}"/>
                </a:ext>
              </a:extLst>
            </p:cNvPr>
            <p:cNvGrpSpPr/>
            <p:nvPr/>
          </p:nvGrpSpPr>
          <p:grpSpPr>
            <a:xfrm>
              <a:off x="196850" y="412556"/>
              <a:ext cx="10968989" cy="6032888"/>
              <a:chOff x="1536699" y="113830"/>
              <a:chExt cx="10968989" cy="6032888"/>
            </a:xfrm>
          </p:grpSpPr>
          <p:sp>
            <p:nvSpPr>
              <p:cNvPr id="11" name="직사각형 10">
                <a:extLst>
                  <a:ext uri="{FF2B5EF4-FFF2-40B4-BE49-F238E27FC236}">
                    <a16:creationId xmlns:a16="http://schemas.microsoft.com/office/drawing/2014/main" id="{703FD62E-E4D9-4F89-A79B-43ECF0F1917F}"/>
                  </a:ext>
                </a:extLst>
              </p:cNvPr>
              <p:cNvSpPr/>
              <p:nvPr/>
            </p:nvSpPr>
            <p:spPr>
              <a:xfrm>
                <a:off x="2844799" y="4467553"/>
                <a:ext cx="2275840" cy="561703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6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mpleted (N=13)</a:t>
                </a:r>
                <a:endParaRPr lang="ko-KR" altLang="en-US" sz="1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직사각형 12">
                <a:extLst>
                  <a:ext uri="{FF2B5EF4-FFF2-40B4-BE49-F238E27FC236}">
                    <a16:creationId xmlns:a16="http://schemas.microsoft.com/office/drawing/2014/main" id="{62A7E551-5FDF-47A2-83A0-846408C6BF91}"/>
                  </a:ext>
                </a:extLst>
              </p:cNvPr>
              <p:cNvSpPr/>
              <p:nvPr/>
            </p:nvSpPr>
            <p:spPr>
              <a:xfrm>
                <a:off x="7960359" y="4467553"/>
                <a:ext cx="2275840" cy="561703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6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mpleted (N=11)</a:t>
                </a:r>
                <a:endParaRPr lang="ko-KR" altLang="en-US" sz="1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직사각형 13">
                <a:extLst>
                  <a:ext uri="{FF2B5EF4-FFF2-40B4-BE49-F238E27FC236}">
                    <a16:creationId xmlns:a16="http://schemas.microsoft.com/office/drawing/2014/main" id="{6C2A07EA-ADD5-4871-83B8-CAE9B4711B49}"/>
                  </a:ext>
                </a:extLst>
              </p:cNvPr>
              <p:cNvSpPr/>
              <p:nvPr/>
            </p:nvSpPr>
            <p:spPr>
              <a:xfrm>
                <a:off x="6845299" y="5585012"/>
                <a:ext cx="2275840" cy="561703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6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aintained (N=10)</a:t>
                </a:r>
                <a:endParaRPr lang="ko-KR" altLang="en-US" sz="1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직사각형 15">
                <a:extLst>
                  <a:ext uri="{FF2B5EF4-FFF2-40B4-BE49-F238E27FC236}">
                    <a16:creationId xmlns:a16="http://schemas.microsoft.com/office/drawing/2014/main" id="{75A8EEED-621F-4CDB-96E1-204EBCE422DD}"/>
                  </a:ext>
                </a:extLst>
              </p:cNvPr>
              <p:cNvSpPr/>
              <p:nvPr/>
            </p:nvSpPr>
            <p:spPr>
              <a:xfrm>
                <a:off x="3942079" y="5585014"/>
                <a:ext cx="2275840" cy="561703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6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hanged medication (N=1)</a:t>
                </a:r>
                <a:endParaRPr lang="ko-KR" altLang="en-US" sz="1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직사각형 16">
                <a:extLst>
                  <a:ext uri="{FF2B5EF4-FFF2-40B4-BE49-F238E27FC236}">
                    <a16:creationId xmlns:a16="http://schemas.microsoft.com/office/drawing/2014/main" id="{BD58747D-66D2-4D8F-8F1E-52F493C16F73}"/>
                  </a:ext>
                </a:extLst>
              </p:cNvPr>
              <p:cNvSpPr/>
              <p:nvPr/>
            </p:nvSpPr>
            <p:spPr>
              <a:xfrm>
                <a:off x="1536699" y="5585013"/>
                <a:ext cx="2275840" cy="561703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6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aintained (N=12)</a:t>
                </a:r>
                <a:endParaRPr lang="ko-KR" altLang="en-US" sz="1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직사각형 20">
                <a:extLst>
                  <a:ext uri="{FF2B5EF4-FFF2-40B4-BE49-F238E27FC236}">
                    <a16:creationId xmlns:a16="http://schemas.microsoft.com/office/drawing/2014/main" id="{6FE432FE-84AD-4635-85BE-245CE7B9B1D9}"/>
                  </a:ext>
                </a:extLst>
              </p:cNvPr>
              <p:cNvSpPr/>
              <p:nvPr/>
            </p:nvSpPr>
            <p:spPr>
              <a:xfrm>
                <a:off x="9291319" y="5585015"/>
                <a:ext cx="2275840" cy="561703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6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hanged medication (N=1)</a:t>
                </a:r>
                <a:endParaRPr lang="ko-KR" altLang="en-US" sz="1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3" name="직선 화살표 연결선 42">
                <a:extLst>
                  <a:ext uri="{FF2B5EF4-FFF2-40B4-BE49-F238E27FC236}">
                    <a16:creationId xmlns:a16="http://schemas.microsoft.com/office/drawing/2014/main" id="{9FAA4FF7-0438-4962-A716-E4B23041C96F}"/>
                  </a:ext>
                </a:extLst>
              </p:cNvPr>
              <p:cNvCxnSpPr>
                <a:stCxn id="11" idx="2"/>
                <a:endCxn id="17" idx="0"/>
              </p:cNvCxnSpPr>
              <p:nvPr/>
            </p:nvCxnSpPr>
            <p:spPr>
              <a:xfrm flipH="1">
                <a:off x="2674619" y="5029256"/>
                <a:ext cx="1308100" cy="555757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" name="직선 화살표 연결선 43">
                <a:extLst>
                  <a:ext uri="{FF2B5EF4-FFF2-40B4-BE49-F238E27FC236}">
                    <a16:creationId xmlns:a16="http://schemas.microsoft.com/office/drawing/2014/main" id="{45548DD2-B0FE-4925-A959-B3EBE155390D}"/>
                  </a:ext>
                </a:extLst>
              </p:cNvPr>
              <p:cNvCxnSpPr>
                <a:cxnSpLocks/>
                <a:endCxn id="14" idx="0"/>
              </p:cNvCxnSpPr>
              <p:nvPr/>
            </p:nvCxnSpPr>
            <p:spPr>
              <a:xfrm flipH="1">
                <a:off x="7983219" y="5023309"/>
                <a:ext cx="1064260" cy="561703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7" name="직선 화살표 연결선 46">
                <a:extLst>
                  <a:ext uri="{FF2B5EF4-FFF2-40B4-BE49-F238E27FC236}">
                    <a16:creationId xmlns:a16="http://schemas.microsoft.com/office/drawing/2014/main" id="{AB33C3B1-5CA3-44F9-AF2C-8039BAEAD45D}"/>
                  </a:ext>
                </a:extLst>
              </p:cNvPr>
              <p:cNvCxnSpPr>
                <a:cxnSpLocks/>
                <a:stCxn id="11" idx="2"/>
              </p:cNvCxnSpPr>
              <p:nvPr/>
            </p:nvCxnSpPr>
            <p:spPr>
              <a:xfrm>
                <a:off x="3982719" y="5029256"/>
                <a:ext cx="1137920" cy="55575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직선 화살표 연결선 48">
                <a:extLst>
                  <a:ext uri="{FF2B5EF4-FFF2-40B4-BE49-F238E27FC236}">
                    <a16:creationId xmlns:a16="http://schemas.microsoft.com/office/drawing/2014/main" id="{42D1B4D9-E9CF-42A3-99E0-E2CA60813B1F}"/>
                  </a:ext>
                </a:extLst>
              </p:cNvPr>
              <p:cNvCxnSpPr>
                <a:stCxn id="13" idx="2"/>
                <a:endCxn id="21" idx="0"/>
              </p:cNvCxnSpPr>
              <p:nvPr/>
            </p:nvCxnSpPr>
            <p:spPr>
              <a:xfrm>
                <a:off x="9098279" y="5029256"/>
                <a:ext cx="1330960" cy="55575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3" name="그룹 52">
                <a:extLst>
                  <a:ext uri="{FF2B5EF4-FFF2-40B4-BE49-F238E27FC236}">
                    <a16:creationId xmlns:a16="http://schemas.microsoft.com/office/drawing/2014/main" id="{0A9BE2F1-82F3-43F0-A9E5-D3C6DB03074B}"/>
                  </a:ext>
                </a:extLst>
              </p:cNvPr>
              <p:cNvGrpSpPr/>
              <p:nvPr/>
            </p:nvGrpSpPr>
            <p:grpSpPr>
              <a:xfrm>
                <a:off x="2844799" y="113830"/>
                <a:ext cx="9660889" cy="4380663"/>
                <a:chOff x="2804159" y="113830"/>
                <a:chExt cx="9660889" cy="4380663"/>
              </a:xfrm>
            </p:grpSpPr>
            <p:sp>
              <p:nvSpPr>
                <p:cNvPr id="5" name="직사각형 4">
                  <a:extLst>
                    <a:ext uri="{FF2B5EF4-FFF2-40B4-BE49-F238E27FC236}">
                      <a16:creationId xmlns:a16="http://schemas.microsoft.com/office/drawing/2014/main" id="{DAB5B020-B0EA-4C44-8AE0-E8D7BF8BC37C}"/>
                    </a:ext>
                  </a:extLst>
                </p:cNvPr>
                <p:cNvSpPr/>
                <p:nvPr/>
              </p:nvSpPr>
              <p:spPr>
                <a:xfrm>
                  <a:off x="5293359" y="113830"/>
                  <a:ext cx="2275839" cy="561703"/>
                </a:xfrm>
                <a:prstGeom prst="rect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6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creened (N=26)</a:t>
                  </a:r>
                  <a:endParaRPr lang="ko-KR" altLang="en-US" sz="16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" name="직사각형 5">
                  <a:extLst>
                    <a:ext uri="{FF2B5EF4-FFF2-40B4-BE49-F238E27FC236}">
                      <a16:creationId xmlns:a16="http://schemas.microsoft.com/office/drawing/2014/main" id="{9CD1896B-E80A-4E1D-A040-0BDB5A3D154A}"/>
                    </a:ext>
                  </a:extLst>
                </p:cNvPr>
                <p:cNvSpPr/>
                <p:nvPr/>
              </p:nvSpPr>
              <p:spPr>
                <a:xfrm>
                  <a:off x="5293359" y="1991014"/>
                  <a:ext cx="2275839" cy="561703"/>
                </a:xfrm>
                <a:prstGeom prst="rect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6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andomized (N=25)</a:t>
                  </a:r>
                  <a:endParaRPr lang="ko-KR" altLang="en-US" sz="16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직사각형 6">
                  <a:extLst>
                    <a:ext uri="{FF2B5EF4-FFF2-40B4-BE49-F238E27FC236}">
                      <a16:creationId xmlns:a16="http://schemas.microsoft.com/office/drawing/2014/main" id="{437B5799-0230-4B9C-A982-7BC72DBC2FD3}"/>
                    </a:ext>
                  </a:extLst>
                </p:cNvPr>
                <p:cNvSpPr/>
                <p:nvPr/>
              </p:nvSpPr>
              <p:spPr>
                <a:xfrm>
                  <a:off x="7919719" y="974455"/>
                  <a:ext cx="3545839" cy="561703"/>
                </a:xfrm>
                <a:prstGeom prst="rect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6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creening failure (N=1)</a:t>
                  </a:r>
                  <a:endParaRPr lang="ko-KR" altLang="en-US" sz="16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직사각형 7">
                  <a:extLst>
                    <a:ext uri="{FF2B5EF4-FFF2-40B4-BE49-F238E27FC236}">
                      <a16:creationId xmlns:a16="http://schemas.microsoft.com/office/drawing/2014/main" id="{58787FC2-2536-40F8-B92C-9E0A12BF947A}"/>
                    </a:ext>
                  </a:extLst>
                </p:cNvPr>
                <p:cNvSpPr/>
                <p:nvPr/>
              </p:nvSpPr>
              <p:spPr>
                <a:xfrm>
                  <a:off x="2804159" y="3025367"/>
                  <a:ext cx="2275840" cy="561703"/>
                </a:xfrm>
                <a:prstGeom prst="rect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6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ulaglutide (N=13)</a:t>
                  </a:r>
                  <a:endParaRPr lang="ko-KR" altLang="en-US" sz="16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직사각형 8">
                  <a:extLst>
                    <a:ext uri="{FF2B5EF4-FFF2-40B4-BE49-F238E27FC236}">
                      <a16:creationId xmlns:a16="http://schemas.microsoft.com/office/drawing/2014/main" id="{F6AC1D4E-DEF7-40BD-8B9A-5AB2C481D6D9}"/>
                    </a:ext>
                  </a:extLst>
                </p:cNvPr>
                <p:cNvSpPr/>
                <p:nvPr/>
              </p:nvSpPr>
              <p:spPr>
                <a:xfrm>
                  <a:off x="7909559" y="3052307"/>
                  <a:ext cx="2275840" cy="561703"/>
                </a:xfrm>
                <a:prstGeom prst="rect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6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mpagliflozin (N=12)</a:t>
                  </a:r>
                  <a:endParaRPr lang="ko-KR" altLang="en-US" sz="16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직사각형 9">
                  <a:extLst>
                    <a:ext uri="{FF2B5EF4-FFF2-40B4-BE49-F238E27FC236}">
                      <a16:creationId xmlns:a16="http://schemas.microsoft.com/office/drawing/2014/main" id="{8BEFDC78-53B3-445B-86A9-0BB76853B01E}"/>
                    </a:ext>
                  </a:extLst>
                </p:cNvPr>
                <p:cNvSpPr/>
                <p:nvPr/>
              </p:nvSpPr>
              <p:spPr>
                <a:xfrm>
                  <a:off x="10571479" y="3753775"/>
                  <a:ext cx="1893569" cy="561703"/>
                </a:xfrm>
                <a:prstGeom prst="rect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6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Lost to follow-up </a:t>
                  </a:r>
                </a:p>
                <a:p>
                  <a:pPr algn="ctr"/>
                  <a:r>
                    <a:rPr lang="en-US" altLang="ko-KR" sz="16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t visit 2 (N=1)</a:t>
                  </a:r>
                  <a:endParaRPr lang="ko-KR" altLang="en-US" sz="16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3" name="직선 화살표 연결선 22">
                  <a:extLst>
                    <a:ext uri="{FF2B5EF4-FFF2-40B4-BE49-F238E27FC236}">
                      <a16:creationId xmlns:a16="http://schemas.microsoft.com/office/drawing/2014/main" id="{84078C3A-7C12-49A8-8E04-4820FE95AE14}"/>
                    </a:ext>
                  </a:extLst>
                </p:cNvPr>
                <p:cNvCxnSpPr>
                  <a:stCxn id="5" idx="2"/>
                  <a:endCxn id="6" idx="0"/>
                </p:cNvCxnSpPr>
                <p:nvPr/>
              </p:nvCxnSpPr>
              <p:spPr>
                <a:xfrm>
                  <a:off x="6431279" y="675533"/>
                  <a:ext cx="0" cy="1315481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직선 연결선 30">
                  <a:extLst>
                    <a:ext uri="{FF2B5EF4-FFF2-40B4-BE49-F238E27FC236}">
                      <a16:creationId xmlns:a16="http://schemas.microsoft.com/office/drawing/2014/main" id="{5B6BF0B1-B154-41E8-A2F3-1C948FC866E4}"/>
                    </a:ext>
                  </a:extLst>
                </p:cNvPr>
                <p:cNvCxnSpPr>
                  <a:stCxn id="6" idx="2"/>
                </p:cNvCxnSpPr>
                <p:nvPr/>
              </p:nvCxnSpPr>
              <p:spPr>
                <a:xfrm flipH="1">
                  <a:off x="6431278" y="2552717"/>
                  <a:ext cx="1" cy="210803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직선 연결선 32">
                  <a:extLst>
                    <a:ext uri="{FF2B5EF4-FFF2-40B4-BE49-F238E27FC236}">
                      <a16:creationId xmlns:a16="http://schemas.microsoft.com/office/drawing/2014/main" id="{52F5F42E-1EB2-4418-8D0A-85A8718A70E9}"/>
                    </a:ext>
                  </a:extLst>
                </p:cNvPr>
                <p:cNvCxnSpPr>
                  <a:endCxn id="8" idx="0"/>
                </p:cNvCxnSpPr>
                <p:nvPr/>
              </p:nvCxnSpPr>
              <p:spPr>
                <a:xfrm>
                  <a:off x="3942079" y="2763520"/>
                  <a:ext cx="0" cy="261847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직선 연결선 34">
                  <a:extLst>
                    <a:ext uri="{FF2B5EF4-FFF2-40B4-BE49-F238E27FC236}">
                      <a16:creationId xmlns:a16="http://schemas.microsoft.com/office/drawing/2014/main" id="{49FEDD8B-5C14-497C-854C-BE05B83F11FD}"/>
                    </a:ext>
                  </a:extLst>
                </p:cNvPr>
                <p:cNvCxnSpPr>
                  <a:cxnSpLocks/>
                  <a:endCxn id="9" idx="0"/>
                </p:cNvCxnSpPr>
                <p:nvPr/>
              </p:nvCxnSpPr>
              <p:spPr>
                <a:xfrm>
                  <a:off x="9047479" y="2763520"/>
                  <a:ext cx="0" cy="288787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직선 화살표 연결선 39">
                  <a:extLst>
                    <a:ext uri="{FF2B5EF4-FFF2-40B4-BE49-F238E27FC236}">
                      <a16:creationId xmlns:a16="http://schemas.microsoft.com/office/drawing/2014/main" id="{790FDFE3-7F62-405E-8057-8EA2049463AC}"/>
                    </a:ext>
                  </a:extLst>
                </p:cNvPr>
                <p:cNvCxnSpPr>
                  <a:stCxn id="8" idx="2"/>
                  <a:endCxn id="11" idx="0"/>
                </p:cNvCxnSpPr>
                <p:nvPr/>
              </p:nvCxnSpPr>
              <p:spPr>
                <a:xfrm>
                  <a:off x="3942079" y="3587070"/>
                  <a:ext cx="0" cy="880483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직선 화살표 연결선 40">
                  <a:extLst>
                    <a:ext uri="{FF2B5EF4-FFF2-40B4-BE49-F238E27FC236}">
                      <a16:creationId xmlns:a16="http://schemas.microsoft.com/office/drawing/2014/main" id="{D2C1F7AC-F0F2-4F4A-A7A8-E8DE6F2BC1E3}"/>
                    </a:ext>
                  </a:extLst>
                </p:cNvPr>
                <p:cNvCxnSpPr/>
                <p:nvPr/>
              </p:nvCxnSpPr>
              <p:spPr>
                <a:xfrm>
                  <a:off x="9057639" y="3614010"/>
                  <a:ext cx="0" cy="880483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직선 화살표 연결선 50">
                  <a:extLst>
                    <a:ext uri="{FF2B5EF4-FFF2-40B4-BE49-F238E27FC236}">
                      <a16:creationId xmlns:a16="http://schemas.microsoft.com/office/drawing/2014/main" id="{161F488C-E304-4DC4-85D2-6C1D9FF1C92B}"/>
                    </a:ext>
                  </a:extLst>
                </p:cNvPr>
                <p:cNvCxnSpPr>
                  <a:endCxn id="7" idx="1"/>
                </p:cNvCxnSpPr>
                <p:nvPr/>
              </p:nvCxnSpPr>
              <p:spPr>
                <a:xfrm>
                  <a:off x="6431278" y="1255306"/>
                  <a:ext cx="1488441" cy="1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직선 화살표 연결선 51">
                  <a:extLst>
                    <a:ext uri="{FF2B5EF4-FFF2-40B4-BE49-F238E27FC236}">
                      <a16:creationId xmlns:a16="http://schemas.microsoft.com/office/drawing/2014/main" id="{06DB8547-F62E-4B93-B749-FD043391BB14}"/>
                    </a:ext>
                  </a:extLst>
                </p:cNvPr>
                <p:cNvCxnSpPr/>
                <p:nvPr/>
              </p:nvCxnSpPr>
              <p:spPr>
                <a:xfrm>
                  <a:off x="9072877" y="4054251"/>
                  <a:ext cx="1488441" cy="1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59" name="화살표: 아래쪽 58">
            <a:extLst>
              <a:ext uri="{FF2B5EF4-FFF2-40B4-BE49-F238E27FC236}">
                <a16:creationId xmlns:a16="http://schemas.microsoft.com/office/drawing/2014/main" id="{347BA95B-3D1A-4AC5-81F1-ABCF79C8B528}"/>
              </a:ext>
            </a:extLst>
          </p:cNvPr>
          <p:cNvSpPr/>
          <p:nvPr/>
        </p:nvSpPr>
        <p:spPr>
          <a:xfrm>
            <a:off x="122573" y="711281"/>
            <a:ext cx="701658" cy="4724317"/>
          </a:xfrm>
          <a:prstGeom prst="downArrow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0" name="화살표: 아래쪽 59">
            <a:extLst>
              <a:ext uri="{FF2B5EF4-FFF2-40B4-BE49-F238E27FC236}">
                <a16:creationId xmlns:a16="http://schemas.microsoft.com/office/drawing/2014/main" id="{E75F9FC1-C9A4-47B4-9655-F6EAC2EAB0D5}"/>
              </a:ext>
            </a:extLst>
          </p:cNvPr>
          <p:cNvSpPr/>
          <p:nvPr/>
        </p:nvSpPr>
        <p:spPr>
          <a:xfrm>
            <a:off x="142879" y="5522148"/>
            <a:ext cx="681352" cy="1335852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115666B-ADB8-4F13-AB7C-999A64E0DDB2}"/>
              </a:ext>
            </a:extLst>
          </p:cNvPr>
          <p:cNvSpPr txBox="1"/>
          <p:nvPr/>
        </p:nvSpPr>
        <p:spPr>
          <a:xfrm rot="16200000">
            <a:off x="-373959" y="2294066"/>
            <a:ext cx="16577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C883A8D2-546D-4DEF-A078-E2E8E21AB136}"/>
              </a:ext>
            </a:extLst>
          </p:cNvPr>
          <p:cNvSpPr txBox="1"/>
          <p:nvPr/>
        </p:nvSpPr>
        <p:spPr>
          <a:xfrm rot="16200000">
            <a:off x="-189666" y="5932047"/>
            <a:ext cx="13622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tension</a:t>
            </a:r>
            <a:endParaRPr lang="ko-KR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58156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EF12300-65E2-4F71-AD47-D721005E9B44}"/>
              </a:ext>
            </a:extLst>
          </p:cNvPr>
          <p:cNvSpPr txBox="1"/>
          <p:nvPr/>
        </p:nvSpPr>
        <p:spPr>
          <a:xfrm>
            <a:off x="560717" y="394682"/>
            <a:ext cx="17300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sz="2000" b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ko-KR" altLang="en-US" sz="20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kumimoji="1" lang="ko-KR" altLang="en-US" sz="20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ko-Kore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BE97A4B-C640-0E8E-6972-F7B089106A7F}"/>
              </a:ext>
            </a:extLst>
          </p:cNvPr>
          <p:cNvSpPr txBox="1"/>
          <p:nvPr/>
        </p:nvSpPr>
        <p:spPr>
          <a:xfrm>
            <a:off x="5103764" y="5982511"/>
            <a:ext cx="2462449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/>
              <a:t>Absolute change from baseline HbA1c (%)</a:t>
            </a:r>
            <a:endParaRPr lang="ko-KR" altLang="en-US" sz="1400" b="1" dirty="0"/>
          </a:p>
        </p:txBody>
      </p:sp>
      <p:grpSp>
        <p:nvGrpSpPr>
          <p:cNvPr id="8" name="그룹 7">
            <a:extLst>
              <a:ext uri="{FF2B5EF4-FFF2-40B4-BE49-F238E27FC236}">
                <a16:creationId xmlns:a16="http://schemas.microsoft.com/office/drawing/2014/main" id="{43041474-0839-4374-9BB6-A8F6A870A508}"/>
              </a:ext>
            </a:extLst>
          </p:cNvPr>
          <p:cNvGrpSpPr/>
          <p:nvPr/>
        </p:nvGrpSpPr>
        <p:grpSpPr>
          <a:xfrm>
            <a:off x="341847" y="872185"/>
            <a:ext cx="10830371" cy="5729592"/>
            <a:chOff x="560717" y="901368"/>
            <a:chExt cx="10830371" cy="5729592"/>
          </a:xfrm>
        </p:grpSpPr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48FE3E61-B4EE-4CC4-B11A-5AFD8028099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60717" y="901368"/>
              <a:ext cx="10830371" cy="5729592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0A5C155-9945-42E4-BC89-0DDB51623D02}"/>
                </a:ext>
              </a:extLst>
            </p:cNvPr>
            <p:cNvSpPr txBox="1"/>
            <p:nvPr/>
          </p:nvSpPr>
          <p:spPr>
            <a:xfrm>
              <a:off x="1118681" y="4786009"/>
              <a:ext cx="177043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Dulaglutide</a:t>
              </a:r>
              <a:endParaRPr lang="ko-KR" altLang="en-US" sz="1200" b="1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86269B6-C482-4935-9918-BED53CFEA7B6}"/>
                </a:ext>
              </a:extLst>
            </p:cNvPr>
            <p:cNvSpPr txBox="1"/>
            <p:nvPr/>
          </p:nvSpPr>
          <p:spPr>
            <a:xfrm>
              <a:off x="1118681" y="5083846"/>
              <a:ext cx="177043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Empagliflozin</a:t>
              </a:r>
              <a:endParaRPr lang="ko-KR" altLang="en-US" sz="1200" b="1" dirty="0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61AD43AD-AA9D-EBCD-4BF3-3B9D823BDA26}"/>
              </a:ext>
            </a:extLst>
          </p:cNvPr>
          <p:cNvSpPr txBox="1"/>
          <p:nvPr/>
        </p:nvSpPr>
        <p:spPr>
          <a:xfrm>
            <a:off x="9828178" y="1217308"/>
            <a:ext cx="2363822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Percentage change from baseline weight (%)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286042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그룹 43">
            <a:extLst>
              <a:ext uri="{FF2B5EF4-FFF2-40B4-BE49-F238E27FC236}">
                <a16:creationId xmlns:a16="http://schemas.microsoft.com/office/drawing/2014/main" id="{D1958519-54F2-45FD-B731-7439CCCC4A94}"/>
              </a:ext>
            </a:extLst>
          </p:cNvPr>
          <p:cNvGrpSpPr/>
          <p:nvPr/>
        </p:nvGrpSpPr>
        <p:grpSpPr>
          <a:xfrm>
            <a:off x="1658922" y="5902423"/>
            <a:ext cx="1693717" cy="497291"/>
            <a:chOff x="4111336" y="1203017"/>
            <a:chExt cx="1693717" cy="497291"/>
          </a:xfrm>
        </p:grpSpPr>
        <p:cxnSp>
          <p:nvCxnSpPr>
            <p:cNvPr id="45" name="직선 연결선 44">
              <a:extLst>
                <a:ext uri="{FF2B5EF4-FFF2-40B4-BE49-F238E27FC236}">
                  <a16:creationId xmlns:a16="http://schemas.microsoft.com/office/drawing/2014/main" id="{2E64DB4D-A792-4C4C-B32C-E56D9C6CE6AA}"/>
                </a:ext>
              </a:extLst>
            </p:cNvPr>
            <p:cNvCxnSpPr/>
            <p:nvPr/>
          </p:nvCxnSpPr>
          <p:spPr>
            <a:xfrm>
              <a:off x="4111336" y="1561809"/>
              <a:ext cx="436418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직선 연결선 45">
              <a:extLst>
                <a:ext uri="{FF2B5EF4-FFF2-40B4-BE49-F238E27FC236}">
                  <a16:creationId xmlns:a16="http://schemas.microsoft.com/office/drawing/2014/main" id="{BDCFF3F5-97D9-4B8D-8425-EB5200764A69}"/>
                </a:ext>
              </a:extLst>
            </p:cNvPr>
            <p:cNvCxnSpPr/>
            <p:nvPr/>
          </p:nvCxnSpPr>
          <p:spPr>
            <a:xfrm>
              <a:off x="4111336" y="1361814"/>
              <a:ext cx="436418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D6F41942-5CF7-4F8D-9DFC-58B38BF2DF74}"/>
                </a:ext>
              </a:extLst>
            </p:cNvPr>
            <p:cNvSpPr txBox="1"/>
            <p:nvPr/>
          </p:nvSpPr>
          <p:spPr>
            <a:xfrm>
              <a:off x="4547754" y="1203017"/>
              <a:ext cx="10711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Dulaglutide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1A88C6D-46E6-4D5B-9356-8C52C11787CA}"/>
                </a:ext>
              </a:extLst>
            </p:cNvPr>
            <p:cNvSpPr txBox="1"/>
            <p:nvPr/>
          </p:nvSpPr>
          <p:spPr>
            <a:xfrm>
              <a:off x="4547754" y="1423309"/>
              <a:ext cx="12572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Empagliflozin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" name="그룹 48">
            <a:extLst>
              <a:ext uri="{FF2B5EF4-FFF2-40B4-BE49-F238E27FC236}">
                <a16:creationId xmlns:a16="http://schemas.microsoft.com/office/drawing/2014/main" id="{E6B6F61D-DB1D-44BE-B7A6-5AC7B2A4347A}"/>
              </a:ext>
            </a:extLst>
          </p:cNvPr>
          <p:cNvGrpSpPr/>
          <p:nvPr/>
        </p:nvGrpSpPr>
        <p:grpSpPr>
          <a:xfrm>
            <a:off x="7306472" y="5874069"/>
            <a:ext cx="1693717" cy="497291"/>
            <a:chOff x="4111336" y="1203017"/>
            <a:chExt cx="1693717" cy="497291"/>
          </a:xfrm>
        </p:grpSpPr>
        <p:cxnSp>
          <p:nvCxnSpPr>
            <p:cNvPr id="50" name="직선 연결선 49">
              <a:extLst>
                <a:ext uri="{FF2B5EF4-FFF2-40B4-BE49-F238E27FC236}">
                  <a16:creationId xmlns:a16="http://schemas.microsoft.com/office/drawing/2014/main" id="{4AF3F232-37D1-478D-A081-114D1422B09A}"/>
                </a:ext>
              </a:extLst>
            </p:cNvPr>
            <p:cNvCxnSpPr/>
            <p:nvPr/>
          </p:nvCxnSpPr>
          <p:spPr>
            <a:xfrm>
              <a:off x="4111336" y="1561809"/>
              <a:ext cx="436418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직선 연결선 50">
              <a:extLst>
                <a:ext uri="{FF2B5EF4-FFF2-40B4-BE49-F238E27FC236}">
                  <a16:creationId xmlns:a16="http://schemas.microsoft.com/office/drawing/2014/main" id="{FCF3798A-14D1-45AA-948B-0848F302DB41}"/>
                </a:ext>
              </a:extLst>
            </p:cNvPr>
            <p:cNvCxnSpPr/>
            <p:nvPr/>
          </p:nvCxnSpPr>
          <p:spPr>
            <a:xfrm>
              <a:off x="4111336" y="1361814"/>
              <a:ext cx="436418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953EE176-D426-41AC-A49C-5918287E8BD8}"/>
                </a:ext>
              </a:extLst>
            </p:cNvPr>
            <p:cNvSpPr txBox="1"/>
            <p:nvPr/>
          </p:nvSpPr>
          <p:spPr>
            <a:xfrm>
              <a:off x="4547754" y="1203017"/>
              <a:ext cx="10711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Dulaglutide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C16F2B95-292F-48D0-8B52-AE4D124CCF68}"/>
                </a:ext>
              </a:extLst>
            </p:cNvPr>
            <p:cNvSpPr txBox="1"/>
            <p:nvPr/>
          </p:nvSpPr>
          <p:spPr>
            <a:xfrm>
              <a:off x="4547754" y="1423309"/>
              <a:ext cx="12572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Empagliflozin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그룹 2">
            <a:extLst>
              <a:ext uri="{FF2B5EF4-FFF2-40B4-BE49-F238E27FC236}">
                <a16:creationId xmlns:a16="http://schemas.microsoft.com/office/drawing/2014/main" id="{9416FEB3-6C56-4F87-A246-39C66B028D36}"/>
              </a:ext>
            </a:extLst>
          </p:cNvPr>
          <p:cNvGrpSpPr/>
          <p:nvPr/>
        </p:nvGrpSpPr>
        <p:grpSpPr>
          <a:xfrm>
            <a:off x="376804" y="141439"/>
            <a:ext cx="5728021" cy="3550855"/>
            <a:chOff x="367979" y="361731"/>
            <a:chExt cx="5728021" cy="3550855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2ECB1B6-1C0B-4E1F-8136-B7F005F4378A}"/>
                </a:ext>
              </a:extLst>
            </p:cNvPr>
            <p:cNvSpPr txBox="1"/>
            <p:nvPr/>
          </p:nvSpPr>
          <p:spPr>
            <a:xfrm>
              <a:off x="367979" y="723674"/>
              <a:ext cx="63824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" name="그룹 16">
              <a:extLst>
                <a:ext uri="{FF2B5EF4-FFF2-40B4-BE49-F238E27FC236}">
                  <a16:creationId xmlns:a16="http://schemas.microsoft.com/office/drawing/2014/main" id="{60A27B0B-D8FA-478E-AB6E-507DEF2EB9F5}"/>
                </a:ext>
              </a:extLst>
            </p:cNvPr>
            <p:cNvGrpSpPr/>
            <p:nvPr/>
          </p:nvGrpSpPr>
          <p:grpSpPr>
            <a:xfrm>
              <a:off x="769927" y="361731"/>
              <a:ext cx="4600516" cy="3516491"/>
              <a:chOff x="462845" y="457198"/>
              <a:chExt cx="4218805" cy="3516491"/>
            </a:xfrm>
          </p:grpSpPr>
          <p:pic>
            <p:nvPicPr>
              <p:cNvPr id="5" name="그림 4">
                <a:extLst>
                  <a:ext uri="{FF2B5EF4-FFF2-40B4-BE49-F238E27FC236}">
                    <a16:creationId xmlns:a16="http://schemas.microsoft.com/office/drawing/2014/main" id="{92476A18-2C37-44B8-87F6-778BBACF37C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60273" y="923729"/>
                <a:ext cx="3921377" cy="3049960"/>
              </a:xfrm>
              <a:prstGeom prst="rect">
                <a:avLst/>
              </a:prstGeom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6FDE8835-970A-4159-9E0A-A0EFB6B4A943}"/>
                  </a:ext>
                </a:extLst>
              </p:cNvPr>
              <p:cNvSpPr txBox="1"/>
              <p:nvPr/>
            </p:nvSpPr>
            <p:spPr>
              <a:xfrm rot="16200000">
                <a:off x="-1037652" y="1957695"/>
                <a:ext cx="3293382" cy="2923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3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hange from baseline in HbA1c (%) </a:t>
                </a:r>
                <a:endParaRPr lang="ko-KR" altLang="en-US" sz="13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" name="그룹 33">
              <a:extLst>
                <a:ext uri="{FF2B5EF4-FFF2-40B4-BE49-F238E27FC236}">
                  <a16:creationId xmlns:a16="http://schemas.microsoft.com/office/drawing/2014/main" id="{830E476B-FD90-4C60-8B61-FCF177B5677B}"/>
                </a:ext>
              </a:extLst>
            </p:cNvPr>
            <p:cNvGrpSpPr/>
            <p:nvPr/>
          </p:nvGrpSpPr>
          <p:grpSpPr>
            <a:xfrm>
              <a:off x="3712672" y="1123784"/>
              <a:ext cx="1693717" cy="497291"/>
              <a:chOff x="4111336" y="1203017"/>
              <a:chExt cx="1693717" cy="497291"/>
            </a:xfrm>
          </p:grpSpPr>
          <p:cxnSp>
            <p:nvCxnSpPr>
              <p:cNvPr id="35" name="직선 연결선 34">
                <a:extLst>
                  <a:ext uri="{FF2B5EF4-FFF2-40B4-BE49-F238E27FC236}">
                    <a16:creationId xmlns:a16="http://schemas.microsoft.com/office/drawing/2014/main" id="{2694D3D8-F816-47CE-8282-202D63272362}"/>
                  </a:ext>
                </a:extLst>
              </p:cNvPr>
              <p:cNvCxnSpPr/>
              <p:nvPr/>
            </p:nvCxnSpPr>
            <p:spPr>
              <a:xfrm>
                <a:off x="4111336" y="1561809"/>
                <a:ext cx="436418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직선 연결선 35">
                <a:extLst>
                  <a:ext uri="{FF2B5EF4-FFF2-40B4-BE49-F238E27FC236}">
                    <a16:creationId xmlns:a16="http://schemas.microsoft.com/office/drawing/2014/main" id="{75CE0851-3372-4B50-9E7E-9FF90B6826D2}"/>
                  </a:ext>
                </a:extLst>
              </p:cNvPr>
              <p:cNvCxnSpPr/>
              <p:nvPr/>
            </p:nvCxnSpPr>
            <p:spPr>
              <a:xfrm>
                <a:off x="4111336" y="1361814"/>
                <a:ext cx="436418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99596A6E-307A-4F4F-ADCE-1E5B30287369}"/>
                  </a:ext>
                </a:extLst>
              </p:cNvPr>
              <p:cNvSpPr txBox="1"/>
              <p:nvPr/>
            </p:nvSpPr>
            <p:spPr>
              <a:xfrm>
                <a:off x="4547754" y="1203017"/>
                <a:ext cx="10711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ulaglutide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3F1E5CA3-21BC-4C63-B8F2-E953B98C567D}"/>
                  </a:ext>
                </a:extLst>
              </p:cNvPr>
              <p:cNvSpPr txBox="1"/>
              <p:nvPr/>
            </p:nvSpPr>
            <p:spPr>
              <a:xfrm>
                <a:off x="4547754" y="1423309"/>
                <a:ext cx="125729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Empagliflozin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4" name="직사각형 53">
              <a:extLst>
                <a:ext uri="{FF2B5EF4-FFF2-40B4-BE49-F238E27FC236}">
                  <a16:creationId xmlns:a16="http://schemas.microsoft.com/office/drawing/2014/main" id="{221A18BF-8BDB-4EEA-B6DA-EB5457E1F8E0}"/>
                </a:ext>
              </a:extLst>
            </p:cNvPr>
            <p:cNvSpPr/>
            <p:nvPr/>
          </p:nvSpPr>
          <p:spPr>
            <a:xfrm>
              <a:off x="1573259" y="3703101"/>
              <a:ext cx="1189820" cy="209485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2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ial </a:t>
              </a:r>
              <a:endParaRPr lang="ko-KR" altLang="en-US" sz="12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직사각형 54">
              <a:extLst>
                <a:ext uri="{FF2B5EF4-FFF2-40B4-BE49-F238E27FC236}">
                  <a16:creationId xmlns:a16="http://schemas.microsoft.com/office/drawing/2014/main" id="{F131A70B-3844-4765-A416-07DB03E4BC4A}"/>
                </a:ext>
              </a:extLst>
            </p:cNvPr>
            <p:cNvSpPr/>
            <p:nvPr/>
          </p:nvSpPr>
          <p:spPr>
            <a:xfrm>
              <a:off x="2793808" y="3703101"/>
              <a:ext cx="2426427" cy="20948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2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bservation </a:t>
              </a:r>
              <a:endParaRPr lang="ko-KR" altLang="en-US" sz="1200" b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A2AF1293-F084-4667-A96B-91A6EB41311B}"/>
                </a:ext>
              </a:extLst>
            </p:cNvPr>
            <p:cNvSpPr txBox="1"/>
            <p:nvPr/>
          </p:nvSpPr>
          <p:spPr>
            <a:xfrm>
              <a:off x="5271052" y="3333066"/>
              <a:ext cx="8249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>
                  <a:latin typeface="Arial" panose="020B0604020202020204" pitchFamily="34" charset="0"/>
                  <a:cs typeface="Arial" panose="020B0604020202020204" pitchFamily="34" charset="0"/>
                </a:rPr>
                <a:t>Weeks</a:t>
              </a:r>
              <a:endParaRPr lang="ko-KR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그룹 5">
            <a:extLst>
              <a:ext uri="{FF2B5EF4-FFF2-40B4-BE49-F238E27FC236}">
                <a16:creationId xmlns:a16="http://schemas.microsoft.com/office/drawing/2014/main" id="{6CE74E59-0BA4-40B3-99B5-B445852A39CE}"/>
              </a:ext>
            </a:extLst>
          </p:cNvPr>
          <p:cNvGrpSpPr/>
          <p:nvPr/>
        </p:nvGrpSpPr>
        <p:grpSpPr>
          <a:xfrm>
            <a:off x="5701508" y="-131096"/>
            <a:ext cx="6597361" cy="3846141"/>
            <a:chOff x="5806861" y="90633"/>
            <a:chExt cx="6597361" cy="3846141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C9B927B-9064-4922-81E0-42F3CC6C2575}"/>
                </a:ext>
              </a:extLst>
            </p:cNvPr>
            <p:cNvSpPr txBox="1"/>
            <p:nvPr/>
          </p:nvSpPr>
          <p:spPr>
            <a:xfrm rot="16200000">
              <a:off x="4640777" y="1730643"/>
              <a:ext cx="3612468" cy="33244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hange from baseline in FPG (mg/dL)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그룹 3">
              <a:extLst>
                <a:ext uri="{FF2B5EF4-FFF2-40B4-BE49-F238E27FC236}">
                  <a16:creationId xmlns:a16="http://schemas.microsoft.com/office/drawing/2014/main" id="{3FEE6449-4309-4B82-9DCD-594328AAF4A9}"/>
                </a:ext>
              </a:extLst>
            </p:cNvPr>
            <p:cNvGrpSpPr/>
            <p:nvPr/>
          </p:nvGrpSpPr>
          <p:grpSpPr>
            <a:xfrm>
              <a:off x="5806861" y="727472"/>
              <a:ext cx="6597361" cy="3209302"/>
              <a:chOff x="5798822" y="735228"/>
              <a:chExt cx="6597361" cy="3209302"/>
            </a:xfrm>
          </p:grpSpPr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21FDD779-9B3C-41D7-A066-EBCEA87FF73B}"/>
                  </a:ext>
                </a:extLst>
              </p:cNvPr>
              <p:cNvSpPr txBox="1"/>
              <p:nvPr/>
            </p:nvSpPr>
            <p:spPr>
              <a:xfrm>
                <a:off x="5798822" y="735228"/>
                <a:ext cx="63824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ko-KR" altLang="en-US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" name="그림 1">
                <a:extLst>
                  <a:ext uri="{FF2B5EF4-FFF2-40B4-BE49-F238E27FC236}">
                    <a16:creationId xmlns:a16="http://schemas.microsoft.com/office/drawing/2014/main" id="{C4425A18-4EF4-4807-A908-83D0DC55BF1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526981" y="825133"/>
                <a:ext cx="4382867" cy="3114675"/>
              </a:xfrm>
              <a:prstGeom prst="rect">
                <a:avLst/>
              </a:prstGeom>
            </p:spPr>
          </p:pic>
          <p:grpSp>
            <p:nvGrpSpPr>
              <p:cNvPr id="39" name="그룹 38">
                <a:extLst>
                  <a:ext uri="{FF2B5EF4-FFF2-40B4-BE49-F238E27FC236}">
                    <a16:creationId xmlns:a16="http://schemas.microsoft.com/office/drawing/2014/main" id="{1A2A5E86-9904-419E-973F-25968AF1ED04}"/>
                  </a:ext>
                </a:extLst>
              </p:cNvPr>
              <p:cNvGrpSpPr/>
              <p:nvPr/>
            </p:nvGrpSpPr>
            <p:grpSpPr>
              <a:xfrm>
                <a:off x="10702466" y="1123784"/>
                <a:ext cx="1693717" cy="497291"/>
                <a:chOff x="4111336" y="1203017"/>
                <a:chExt cx="1693717" cy="497291"/>
              </a:xfrm>
            </p:grpSpPr>
            <p:cxnSp>
              <p:nvCxnSpPr>
                <p:cNvPr id="40" name="직선 연결선 39">
                  <a:extLst>
                    <a:ext uri="{FF2B5EF4-FFF2-40B4-BE49-F238E27FC236}">
                      <a16:creationId xmlns:a16="http://schemas.microsoft.com/office/drawing/2014/main" id="{B949C592-8FB6-4670-8869-D92D1D6A4FA3}"/>
                    </a:ext>
                  </a:extLst>
                </p:cNvPr>
                <p:cNvCxnSpPr/>
                <p:nvPr/>
              </p:nvCxnSpPr>
              <p:spPr>
                <a:xfrm>
                  <a:off x="4111336" y="1561809"/>
                  <a:ext cx="436418" cy="0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직선 연결선 40">
                  <a:extLst>
                    <a:ext uri="{FF2B5EF4-FFF2-40B4-BE49-F238E27FC236}">
                      <a16:creationId xmlns:a16="http://schemas.microsoft.com/office/drawing/2014/main" id="{994AC56F-6F33-4F44-8664-FD0878B376F6}"/>
                    </a:ext>
                  </a:extLst>
                </p:cNvPr>
                <p:cNvCxnSpPr/>
                <p:nvPr/>
              </p:nvCxnSpPr>
              <p:spPr>
                <a:xfrm>
                  <a:off x="4111336" y="1361814"/>
                  <a:ext cx="436418" cy="0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31DE1D80-EE68-4DD6-A55B-B55EFA1C3363}"/>
                    </a:ext>
                  </a:extLst>
                </p:cNvPr>
                <p:cNvSpPr txBox="1"/>
                <p:nvPr/>
              </p:nvSpPr>
              <p:spPr>
                <a:xfrm>
                  <a:off x="4547754" y="1203017"/>
                  <a:ext cx="107114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ulaglutide</a:t>
                  </a:r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5EE0D083-5D7A-4235-8AAB-7F4C01FA5CA6}"/>
                    </a:ext>
                  </a:extLst>
                </p:cNvPr>
                <p:cNvSpPr txBox="1"/>
                <p:nvPr/>
              </p:nvSpPr>
              <p:spPr>
                <a:xfrm>
                  <a:off x="4547754" y="1423309"/>
                  <a:ext cx="125729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mpagliflozin</a:t>
                  </a:r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8" name="그룹 27">
                <a:extLst>
                  <a:ext uri="{FF2B5EF4-FFF2-40B4-BE49-F238E27FC236}">
                    <a16:creationId xmlns:a16="http://schemas.microsoft.com/office/drawing/2014/main" id="{85120D46-155B-4327-9258-2DBBF13C6B8E}"/>
                  </a:ext>
                </a:extLst>
              </p:cNvPr>
              <p:cNvGrpSpPr/>
              <p:nvPr/>
            </p:nvGrpSpPr>
            <p:grpSpPr>
              <a:xfrm>
                <a:off x="10659304" y="2074449"/>
                <a:ext cx="382103" cy="669851"/>
                <a:chOff x="11147682" y="1414130"/>
                <a:chExt cx="382103" cy="669851"/>
              </a:xfrm>
            </p:grpSpPr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E2158074-4DFE-4DBA-8A04-5678D829C8D5}"/>
                    </a:ext>
                  </a:extLst>
                </p:cNvPr>
                <p:cNvSpPr txBox="1"/>
                <p:nvPr/>
              </p:nvSpPr>
              <p:spPr>
                <a:xfrm>
                  <a:off x="11147682" y="1566899"/>
                  <a:ext cx="38210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/>
                    <a:t>#</a:t>
                  </a:r>
                  <a:endParaRPr lang="ko-KR" altLang="en-US" sz="1400" dirty="0"/>
                </a:p>
              </p:txBody>
            </p:sp>
            <p:sp>
              <p:nvSpPr>
                <p:cNvPr id="30" name="오른쪽 대괄호 29">
                  <a:extLst>
                    <a:ext uri="{FF2B5EF4-FFF2-40B4-BE49-F238E27FC236}">
                      <a16:creationId xmlns:a16="http://schemas.microsoft.com/office/drawing/2014/main" id="{7CAAC8E3-A952-4ED4-A9E4-E89532F8BC1E}"/>
                    </a:ext>
                  </a:extLst>
                </p:cNvPr>
                <p:cNvSpPr/>
                <p:nvPr/>
              </p:nvSpPr>
              <p:spPr>
                <a:xfrm>
                  <a:off x="11147682" y="1414130"/>
                  <a:ext cx="45719" cy="669851"/>
                </a:xfrm>
                <a:prstGeom prst="rightBracket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grpSp>
            <p:nvGrpSpPr>
              <p:cNvPr id="31" name="그룹 30">
                <a:extLst>
                  <a:ext uri="{FF2B5EF4-FFF2-40B4-BE49-F238E27FC236}">
                    <a16:creationId xmlns:a16="http://schemas.microsoft.com/office/drawing/2014/main" id="{68B95B7D-2A55-4D29-84A0-B3CD36B4F6B3}"/>
                  </a:ext>
                </a:extLst>
              </p:cNvPr>
              <p:cNvGrpSpPr/>
              <p:nvPr/>
            </p:nvGrpSpPr>
            <p:grpSpPr>
              <a:xfrm>
                <a:off x="9465039" y="1621075"/>
                <a:ext cx="837396" cy="1009816"/>
                <a:chOff x="11147682" y="1414130"/>
                <a:chExt cx="418739" cy="669851"/>
              </a:xfrm>
            </p:grpSpPr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E04D4477-D7C8-417C-93F6-6569351CF31E}"/>
                    </a:ext>
                  </a:extLst>
                </p:cNvPr>
                <p:cNvSpPr txBox="1"/>
                <p:nvPr/>
              </p:nvSpPr>
              <p:spPr>
                <a:xfrm>
                  <a:off x="11184318" y="1690321"/>
                  <a:ext cx="382103" cy="2041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/>
                    <a:t>##</a:t>
                  </a:r>
                  <a:endParaRPr lang="ko-KR" altLang="en-US" sz="1400" dirty="0"/>
                </a:p>
              </p:txBody>
            </p:sp>
            <p:sp>
              <p:nvSpPr>
                <p:cNvPr id="33" name="오른쪽 대괄호 32">
                  <a:extLst>
                    <a:ext uri="{FF2B5EF4-FFF2-40B4-BE49-F238E27FC236}">
                      <a16:creationId xmlns:a16="http://schemas.microsoft.com/office/drawing/2014/main" id="{5F09A5B7-69D0-4DF3-BD8C-D9582A097FE3}"/>
                    </a:ext>
                  </a:extLst>
                </p:cNvPr>
                <p:cNvSpPr/>
                <p:nvPr/>
              </p:nvSpPr>
              <p:spPr>
                <a:xfrm>
                  <a:off x="11147682" y="1414130"/>
                  <a:ext cx="45719" cy="669851"/>
                </a:xfrm>
                <a:prstGeom prst="rightBracket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sp>
            <p:nvSpPr>
              <p:cNvPr id="58" name="직사각형 57">
                <a:extLst>
                  <a:ext uri="{FF2B5EF4-FFF2-40B4-BE49-F238E27FC236}">
                    <a16:creationId xmlns:a16="http://schemas.microsoft.com/office/drawing/2014/main" id="{CB6DFDC1-6314-4AAA-AEDE-E95DE98C1A3E}"/>
                  </a:ext>
                </a:extLst>
              </p:cNvPr>
              <p:cNvSpPr/>
              <p:nvPr/>
            </p:nvSpPr>
            <p:spPr>
              <a:xfrm>
                <a:off x="7006925" y="3735045"/>
                <a:ext cx="1189820" cy="209485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2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rial </a:t>
                </a:r>
                <a:endParaRPr lang="ko-KR" altLang="en-US" sz="12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직사각형 58">
                <a:extLst>
                  <a:ext uri="{FF2B5EF4-FFF2-40B4-BE49-F238E27FC236}">
                    <a16:creationId xmlns:a16="http://schemas.microsoft.com/office/drawing/2014/main" id="{570AE040-2B56-4EC0-8F0D-0BA4B879B118}"/>
                  </a:ext>
                </a:extLst>
              </p:cNvPr>
              <p:cNvSpPr/>
              <p:nvPr/>
            </p:nvSpPr>
            <p:spPr>
              <a:xfrm>
                <a:off x="8251825" y="3735045"/>
                <a:ext cx="2426427" cy="209483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200" b="1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bservation </a:t>
                </a:r>
                <a:endParaRPr lang="ko-KR" altLang="en-US" sz="12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249E6810-676B-46A7-BFD6-057D0E0E3BA9}"/>
                  </a:ext>
                </a:extLst>
              </p:cNvPr>
              <p:cNvSpPr txBox="1"/>
              <p:nvPr/>
            </p:nvSpPr>
            <p:spPr>
              <a:xfrm>
                <a:off x="10845823" y="3333066"/>
                <a:ext cx="82494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Weeks</a:t>
                </a:r>
                <a:endParaRPr lang="ko-KR" alt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7A215A69-C9ED-4816-805F-9C1690CC4E31}"/>
              </a:ext>
            </a:extLst>
          </p:cNvPr>
          <p:cNvSpPr txBox="1"/>
          <p:nvPr/>
        </p:nvSpPr>
        <p:spPr>
          <a:xfrm>
            <a:off x="75866" y="52631"/>
            <a:ext cx="17300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sz="2000" b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ko-KR" altLang="en-US" sz="20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kumimoji="1" lang="ko-Kore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86A8AEF3-8756-4C85-B6AB-C64F191A444D}"/>
              </a:ext>
            </a:extLst>
          </p:cNvPr>
          <p:cNvGrpSpPr/>
          <p:nvPr/>
        </p:nvGrpSpPr>
        <p:grpSpPr>
          <a:xfrm>
            <a:off x="343489" y="3690564"/>
            <a:ext cx="5891837" cy="3162917"/>
            <a:chOff x="312379" y="3657930"/>
            <a:chExt cx="5891837" cy="3162917"/>
          </a:xfrm>
        </p:grpSpPr>
        <p:grpSp>
          <p:nvGrpSpPr>
            <p:cNvPr id="23" name="그룹 22">
              <a:extLst>
                <a:ext uri="{FF2B5EF4-FFF2-40B4-BE49-F238E27FC236}">
                  <a16:creationId xmlns:a16="http://schemas.microsoft.com/office/drawing/2014/main" id="{7453874A-EEA2-4973-BB16-55D591A424F2}"/>
                </a:ext>
              </a:extLst>
            </p:cNvPr>
            <p:cNvGrpSpPr/>
            <p:nvPr/>
          </p:nvGrpSpPr>
          <p:grpSpPr>
            <a:xfrm>
              <a:off x="312379" y="3657930"/>
              <a:ext cx="5066889" cy="3072376"/>
              <a:chOff x="450804" y="3785624"/>
              <a:chExt cx="4919639" cy="3072376"/>
            </a:xfrm>
          </p:grpSpPr>
          <p:pic>
            <p:nvPicPr>
              <p:cNvPr id="11" name="그림 10">
                <a:extLst>
                  <a:ext uri="{FF2B5EF4-FFF2-40B4-BE49-F238E27FC236}">
                    <a16:creationId xmlns:a16="http://schemas.microsoft.com/office/drawing/2014/main" id="{FD0E45D8-DF07-4A5B-BEA7-3944A29411F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264325" y="3926210"/>
                <a:ext cx="4106118" cy="2931790"/>
              </a:xfrm>
              <a:prstGeom prst="rect">
                <a:avLst/>
              </a:prstGeom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B28F7421-38FD-4862-A639-11965777DA5C}"/>
                  </a:ext>
                </a:extLst>
              </p:cNvPr>
              <p:cNvSpPr txBox="1"/>
              <p:nvPr/>
            </p:nvSpPr>
            <p:spPr>
              <a:xfrm>
                <a:off x="450804" y="3873204"/>
                <a:ext cx="63824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ko-KR" altLang="en-US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6C252974-A69C-47D8-A4C8-89E109BC3510}"/>
                  </a:ext>
                </a:extLst>
              </p:cNvPr>
              <p:cNvSpPr txBox="1"/>
              <p:nvPr/>
            </p:nvSpPr>
            <p:spPr>
              <a:xfrm rot="16200000">
                <a:off x="-478920" y="5151614"/>
                <a:ext cx="3009017" cy="27703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3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hange from baseline in weight (kg</a:t>
                </a:r>
                <a:r>
                  <a: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1" name="직사각형 60">
              <a:extLst>
                <a:ext uri="{FF2B5EF4-FFF2-40B4-BE49-F238E27FC236}">
                  <a16:creationId xmlns:a16="http://schemas.microsoft.com/office/drawing/2014/main" id="{9523C230-A4DD-4EEA-8C42-CE3421D81691}"/>
                </a:ext>
              </a:extLst>
            </p:cNvPr>
            <p:cNvSpPr/>
            <p:nvPr/>
          </p:nvSpPr>
          <p:spPr>
            <a:xfrm>
              <a:off x="1500430" y="6611362"/>
              <a:ext cx="1189820" cy="209485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2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ial </a:t>
              </a:r>
              <a:endParaRPr lang="ko-KR" altLang="en-US" sz="12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직사각형 61">
              <a:extLst>
                <a:ext uri="{FF2B5EF4-FFF2-40B4-BE49-F238E27FC236}">
                  <a16:creationId xmlns:a16="http://schemas.microsoft.com/office/drawing/2014/main" id="{86F22E57-8C8B-4BC9-ADD7-AD16B9B69F5D}"/>
                </a:ext>
              </a:extLst>
            </p:cNvPr>
            <p:cNvSpPr/>
            <p:nvPr/>
          </p:nvSpPr>
          <p:spPr>
            <a:xfrm>
              <a:off x="2735200" y="6592831"/>
              <a:ext cx="2426427" cy="20948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2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bservation </a:t>
              </a:r>
              <a:endParaRPr lang="ko-KR" altLang="en-US" sz="1200" b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5165A2E4-056B-4D49-ADFC-27DE04E6C5DA}"/>
                </a:ext>
              </a:extLst>
            </p:cNvPr>
            <p:cNvSpPr txBox="1"/>
            <p:nvPr/>
          </p:nvSpPr>
          <p:spPr>
            <a:xfrm>
              <a:off x="5379268" y="6285054"/>
              <a:ext cx="8249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>
                  <a:latin typeface="Arial" panose="020B0604020202020204" pitchFamily="34" charset="0"/>
                  <a:cs typeface="Arial" panose="020B0604020202020204" pitchFamily="34" charset="0"/>
                </a:rPr>
                <a:t>Weeks</a:t>
              </a:r>
              <a:endParaRPr lang="ko-KR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그룹 7">
            <a:extLst>
              <a:ext uri="{FF2B5EF4-FFF2-40B4-BE49-F238E27FC236}">
                <a16:creationId xmlns:a16="http://schemas.microsoft.com/office/drawing/2014/main" id="{F5372C28-BBB5-41D8-B94A-067063411A4F}"/>
              </a:ext>
            </a:extLst>
          </p:cNvPr>
          <p:cNvGrpSpPr/>
          <p:nvPr/>
        </p:nvGrpSpPr>
        <p:grpSpPr>
          <a:xfrm>
            <a:off x="5729448" y="3891387"/>
            <a:ext cx="5938353" cy="2980176"/>
            <a:chOff x="5729448" y="3891387"/>
            <a:chExt cx="5938353" cy="2980176"/>
          </a:xfrm>
        </p:grpSpPr>
        <p:grpSp>
          <p:nvGrpSpPr>
            <p:cNvPr id="27" name="그룹 26">
              <a:extLst>
                <a:ext uri="{FF2B5EF4-FFF2-40B4-BE49-F238E27FC236}">
                  <a16:creationId xmlns:a16="http://schemas.microsoft.com/office/drawing/2014/main" id="{F700C593-979D-4E76-8BF1-FEB7FC59B9C8}"/>
                </a:ext>
              </a:extLst>
            </p:cNvPr>
            <p:cNvGrpSpPr/>
            <p:nvPr/>
          </p:nvGrpSpPr>
          <p:grpSpPr>
            <a:xfrm>
              <a:off x="5729448" y="3891387"/>
              <a:ext cx="5324132" cy="2910927"/>
              <a:chOff x="5854653" y="3853544"/>
              <a:chExt cx="5197660" cy="2910927"/>
            </a:xfrm>
          </p:grpSpPr>
          <p:pic>
            <p:nvPicPr>
              <p:cNvPr id="13" name="그림 12">
                <a:extLst>
                  <a:ext uri="{FF2B5EF4-FFF2-40B4-BE49-F238E27FC236}">
                    <a16:creationId xmlns:a16="http://schemas.microsoft.com/office/drawing/2014/main" id="{55145F8A-D74D-4D34-9F55-30FFA50630C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621724" y="4006024"/>
                <a:ext cx="4430589" cy="2758447"/>
              </a:xfrm>
              <a:prstGeom prst="rect">
                <a:avLst/>
              </a:prstGeom>
            </p:spPr>
          </p:pic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6A627017-C27B-453A-8CA1-2F45A5610374}"/>
                  </a:ext>
                </a:extLst>
              </p:cNvPr>
              <p:cNvSpPr txBox="1"/>
              <p:nvPr/>
            </p:nvSpPr>
            <p:spPr>
              <a:xfrm>
                <a:off x="5854653" y="3853546"/>
                <a:ext cx="63824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ko-KR" altLang="en-US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59C1A084-F741-44B7-A688-227A00B2CFBB}"/>
                  </a:ext>
                </a:extLst>
              </p:cNvPr>
              <p:cNvSpPr txBox="1"/>
              <p:nvPr/>
            </p:nvSpPr>
            <p:spPr>
              <a:xfrm rot="16200000">
                <a:off x="5027496" y="5121748"/>
                <a:ext cx="281340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hange from baseline in BMI (kg/m</a:t>
                </a:r>
                <a:r>
                  <a:rPr lang="en-US" altLang="ko-KR" sz="12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5" name="직사각형 64">
              <a:extLst>
                <a:ext uri="{FF2B5EF4-FFF2-40B4-BE49-F238E27FC236}">
                  <a16:creationId xmlns:a16="http://schemas.microsoft.com/office/drawing/2014/main" id="{3FFAF446-C587-41FE-A8E9-48058C15EE4E}"/>
                </a:ext>
              </a:extLst>
            </p:cNvPr>
            <p:cNvSpPr/>
            <p:nvPr/>
          </p:nvSpPr>
          <p:spPr>
            <a:xfrm>
              <a:off x="7030375" y="6662078"/>
              <a:ext cx="1189820" cy="209485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2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ial </a:t>
              </a:r>
              <a:endParaRPr lang="ko-KR" altLang="en-US" sz="12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직사각형 65">
              <a:extLst>
                <a:ext uri="{FF2B5EF4-FFF2-40B4-BE49-F238E27FC236}">
                  <a16:creationId xmlns:a16="http://schemas.microsoft.com/office/drawing/2014/main" id="{EB14FD76-F350-4BF2-943C-B3ADC765C961}"/>
                </a:ext>
              </a:extLst>
            </p:cNvPr>
            <p:cNvSpPr/>
            <p:nvPr/>
          </p:nvSpPr>
          <p:spPr>
            <a:xfrm>
              <a:off x="8243586" y="6648517"/>
              <a:ext cx="2426427" cy="20948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2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bservation </a:t>
              </a:r>
              <a:endParaRPr lang="ko-KR" altLang="en-US" sz="1200" b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3428097E-9257-4BB1-82CE-99C5412E1E21}"/>
                </a:ext>
              </a:extLst>
            </p:cNvPr>
            <p:cNvSpPr txBox="1"/>
            <p:nvPr/>
          </p:nvSpPr>
          <p:spPr>
            <a:xfrm>
              <a:off x="10842853" y="6316786"/>
              <a:ext cx="8249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>
                  <a:latin typeface="Arial" panose="020B0604020202020204" pitchFamily="34" charset="0"/>
                  <a:cs typeface="Arial" panose="020B0604020202020204" pitchFamily="34" charset="0"/>
                </a:rPr>
                <a:t>Weeks</a:t>
              </a:r>
              <a:endParaRPr lang="ko-KR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1" name="그룹 70">
            <a:extLst>
              <a:ext uri="{FF2B5EF4-FFF2-40B4-BE49-F238E27FC236}">
                <a16:creationId xmlns:a16="http://schemas.microsoft.com/office/drawing/2014/main" id="{245DA0BB-AC3E-4360-8CC7-7C975514A06B}"/>
              </a:ext>
            </a:extLst>
          </p:cNvPr>
          <p:cNvGrpSpPr/>
          <p:nvPr/>
        </p:nvGrpSpPr>
        <p:grpSpPr>
          <a:xfrm>
            <a:off x="10739580" y="4317674"/>
            <a:ext cx="1559290" cy="472988"/>
            <a:chOff x="4111336" y="1203017"/>
            <a:chExt cx="1693717" cy="497291"/>
          </a:xfrm>
        </p:grpSpPr>
        <p:cxnSp>
          <p:nvCxnSpPr>
            <p:cNvPr id="72" name="직선 연결선 71">
              <a:extLst>
                <a:ext uri="{FF2B5EF4-FFF2-40B4-BE49-F238E27FC236}">
                  <a16:creationId xmlns:a16="http://schemas.microsoft.com/office/drawing/2014/main" id="{B2A23E3A-E787-4814-AE5F-E11A6AD34CB5}"/>
                </a:ext>
              </a:extLst>
            </p:cNvPr>
            <p:cNvCxnSpPr/>
            <p:nvPr/>
          </p:nvCxnSpPr>
          <p:spPr>
            <a:xfrm>
              <a:off x="4111336" y="1561809"/>
              <a:ext cx="436418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직선 연결선 72">
              <a:extLst>
                <a:ext uri="{FF2B5EF4-FFF2-40B4-BE49-F238E27FC236}">
                  <a16:creationId xmlns:a16="http://schemas.microsoft.com/office/drawing/2014/main" id="{B66238F6-5815-4426-9680-2C27785A36FB}"/>
                </a:ext>
              </a:extLst>
            </p:cNvPr>
            <p:cNvCxnSpPr/>
            <p:nvPr/>
          </p:nvCxnSpPr>
          <p:spPr>
            <a:xfrm>
              <a:off x="4111336" y="1361814"/>
              <a:ext cx="436418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89CAF0DD-BDD0-472B-B7E4-D0041E76FA68}"/>
                </a:ext>
              </a:extLst>
            </p:cNvPr>
            <p:cNvSpPr txBox="1"/>
            <p:nvPr/>
          </p:nvSpPr>
          <p:spPr>
            <a:xfrm>
              <a:off x="4547754" y="1203017"/>
              <a:ext cx="10711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Dulaglutide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1B97778C-7E8D-48E7-9EDA-7D677D112B6B}"/>
                </a:ext>
              </a:extLst>
            </p:cNvPr>
            <p:cNvSpPr txBox="1"/>
            <p:nvPr/>
          </p:nvSpPr>
          <p:spPr>
            <a:xfrm>
              <a:off x="4547754" y="1423309"/>
              <a:ext cx="12572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Empagliflozin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6" name="그룹 75">
            <a:extLst>
              <a:ext uri="{FF2B5EF4-FFF2-40B4-BE49-F238E27FC236}">
                <a16:creationId xmlns:a16="http://schemas.microsoft.com/office/drawing/2014/main" id="{5EF7D26E-052F-4079-907A-8D34CF52D567}"/>
              </a:ext>
            </a:extLst>
          </p:cNvPr>
          <p:cNvGrpSpPr/>
          <p:nvPr/>
        </p:nvGrpSpPr>
        <p:grpSpPr>
          <a:xfrm>
            <a:off x="4223809" y="4195098"/>
            <a:ext cx="1493680" cy="438069"/>
            <a:chOff x="4111336" y="1203017"/>
            <a:chExt cx="1693717" cy="497291"/>
          </a:xfrm>
        </p:grpSpPr>
        <p:cxnSp>
          <p:nvCxnSpPr>
            <p:cNvPr id="77" name="직선 연결선 76">
              <a:extLst>
                <a:ext uri="{FF2B5EF4-FFF2-40B4-BE49-F238E27FC236}">
                  <a16:creationId xmlns:a16="http://schemas.microsoft.com/office/drawing/2014/main" id="{40485223-07D8-45B9-BD40-542C5D1063CF}"/>
                </a:ext>
              </a:extLst>
            </p:cNvPr>
            <p:cNvCxnSpPr/>
            <p:nvPr/>
          </p:nvCxnSpPr>
          <p:spPr>
            <a:xfrm>
              <a:off x="4111336" y="1561809"/>
              <a:ext cx="436418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직선 연결선 77">
              <a:extLst>
                <a:ext uri="{FF2B5EF4-FFF2-40B4-BE49-F238E27FC236}">
                  <a16:creationId xmlns:a16="http://schemas.microsoft.com/office/drawing/2014/main" id="{03C1DC03-2B73-4DB9-BBBE-A527EC021CA6}"/>
                </a:ext>
              </a:extLst>
            </p:cNvPr>
            <p:cNvCxnSpPr/>
            <p:nvPr/>
          </p:nvCxnSpPr>
          <p:spPr>
            <a:xfrm>
              <a:off x="4111336" y="1361814"/>
              <a:ext cx="436418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10078F6C-2555-4230-830A-C9E1D8074A1E}"/>
                </a:ext>
              </a:extLst>
            </p:cNvPr>
            <p:cNvSpPr txBox="1"/>
            <p:nvPr/>
          </p:nvSpPr>
          <p:spPr>
            <a:xfrm>
              <a:off x="4547754" y="1203017"/>
              <a:ext cx="10711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Dulaglutide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C58F947F-53A8-40CB-9090-0B5A28839902}"/>
                </a:ext>
              </a:extLst>
            </p:cNvPr>
            <p:cNvSpPr txBox="1"/>
            <p:nvPr/>
          </p:nvSpPr>
          <p:spPr>
            <a:xfrm>
              <a:off x="4547754" y="1423309"/>
              <a:ext cx="12572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Empagliflozin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987169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E5E60E4-FD7F-C27F-9240-DF0605C03F95}"/>
              </a:ext>
            </a:extLst>
          </p:cNvPr>
          <p:cNvSpPr txBox="1"/>
          <p:nvPr/>
        </p:nvSpPr>
        <p:spPr>
          <a:xfrm>
            <a:off x="305310" y="716845"/>
            <a:ext cx="331809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ko-KR" sz="1600" b="1"/>
              <a:t>A. Types of plasma bile acids </a:t>
            </a:r>
            <a:endParaRPr kumimoji="1" lang="ko-KR" altLang="en-US" sz="1600" b="1" dirty="0"/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BC960418-1D77-99B1-383B-E1B7E485888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21979" y="4059620"/>
            <a:ext cx="3616208" cy="2893457"/>
          </a:xfrm>
          <a:prstGeom prst="rect">
            <a:avLst/>
          </a:prstGeom>
        </p:spPr>
      </p:pic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07C0473A-CD57-3B30-CBA8-5D15391333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98646873"/>
              </p:ext>
            </p:extLst>
          </p:nvPr>
        </p:nvGraphicFramePr>
        <p:xfrm>
          <a:off x="371035" y="1112837"/>
          <a:ext cx="3318096" cy="2113843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829524">
                  <a:extLst>
                    <a:ext uri="{9D8B030D-6E8A-4147-A177-3AD203B41FA5}">
                      <a16:colId xmlns:a16="http://schemas.microsoft.com/office/drawing/2014/main" val="1098494675"/>
                    </a:ext>
                  </a:extLst>
                </a:gridCol>
                <a:gridCol w="829524">
                  <a:extLst>
                    <a:ext uri="{9D8B030D-6E8A-4147-A177-3AD203B41FA5}">
                      <a16:colId xmlns:a16="http://schemas.microsoft.com/office/drawing/2014/main" val="2286328087"/>
                    </a:ext>
                  </a:extLst>
                </a:gridCol>
                <a:gridCol w="829524">
                  <a:extLst>
                    <a:ext uri="{9D8B030D-6E8A-4147-A177-3AD203B41FA5}">
                      <a16:colId xmlns:a16="http://schemas.microsoft.com/office/drawing/2014/main" val="785331523"/>
                    </a:ext>
                  </a:extLst>
                </a:gridCol>
                <a:gridCol w="829524">
                  <a:extLst>
                    <a:ext uri="{9D8B030D-6E8A-4147-A177-3AD203B41FA5}">
                      <a16:colId xmlns:a16="http://schemas.microsoft.com/office/drawing/2014/main" val="2497441217"/>
                    </a:ext>
                  </a:extLst>
                </a:gridCol>
              </a:tblGrid>
              <a:tr h="190584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ompou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Treatmen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Fold_Chang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p_valu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0575401"/>
                  </a:ext>
                </a:extLst>
              </a:tr>
              <a:tr h="208003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Dulaglutid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2.22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033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96041959"/>
                  </a:ext>
                </a:extLst>
              </a:tr>
              <a:tr h="190584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Empaglifloz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95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85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84547443"/>
                  </a:ext>
                </a:extLst>
              </a:tr>
              <a:tr h="190584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D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Dulaglutid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99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980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00130135"/>
                  </a:ext>
                </a:extLst>
              </a:tr>
              <a:tr h="190584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D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Empaglifloz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79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390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87385565"/>
                  </a:ext>
                </a:extLst>
              </a:tr>
              <a:tr h="190584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G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Dulaglutid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75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14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16159057"/>
                  </a:ext>
                </a:extLst>
              </a:tr>
              <a:tr h="190584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G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Empaglifloz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81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399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12244923"/>
                  </a:ext>
                </a:extLst>
              </a:tr>
              <a:tr h="190584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GCD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Dulaglutid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77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129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95413142"/>
                  </a:ext>
                </a:extLst>
              </a:tr>
              <a:tr h="190584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GCD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Empaglifloz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87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603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15028264"/>
                  </a:ext>
                </a:extLst>
              </a:tr>
              <a:tr h="190584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L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Dulaglutid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1.0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243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11349162"/>
                  </a:ext>
                </a:extLst>
              </a:tr>
              <a:tr h="190584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L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Empaglifloz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95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596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55718079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8AC2E717-C99A-4420-9043-FE3D1F2C649B}"/>
              </a:ext>
            </a:extLst>
          </p:cNvPr>
          <p:cNvSpPr txBox="1"/>
          <p:nvPr/>
        </p:nvSpPr>
        <p:spPr>
          <a:xfrm>
            <a:off x="75866" y="52631"/>
            <a:ext cx="17300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sz="2000" b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ko-KR" altLang="en-US" sz="20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kumimoji="1" lang="ko-Kore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24EABF69-F287-46D2-94E1-7FA2A09B019D}"/>
              </a:ext>
            </a:extLst>
          </p:cNvPr>
          <p:cNvGrpSpPr/>
          <p:nvPr/>
        </p:nvGrpSpPr>
        <p:grpSpPr>
          <a:xfrm>
            <a:off x="4098957" y="716845"/>
            <a:ext cx="3616208" cy="3161472"/>
            <a:chOff x="4098957" y="671083"/>
            <a:chExt cx="3616208" cy="3207234"/>
          </a:xfrm>
        </p:grpSpPr>
        <p:grpSp>
          <p:nvGrpSpPr>
            <p:cNvPr id="6" name="그룹 5">
              <a:extLst>
                <a:ext uri="{FF2B5EF4-FFF2-40B4-BE49-F238E27FC236}">
                  <a16:creationId xmlns:a16="http://schemas.microsoft.com/office/drawing/2014/main" id="{5FC15C4C-97A0-42B1-9707-5419EB6B3459}"/>
                </a:ext>
              </a:extLst>
            </p:cNvPr>
            <p:cNvGrpSpPr/>
            <p:nvPr/>
          </p:nvGrpSpPr>
          <p:grpSpPr>
            <a:xfrm>
              <a:off x="4098957" y="716845"/>
              <a:ext cx="3616208" cy="3161472"/>
              <a:chOff x="3647636" y="705261"/>
              <a:chExt cx="3616208" cy="2712155"/>
            </a:xfrm>
          </p:grpSpPr>
          <p:pic>
            <p:nvPicPr>
              <p:cNvPr id="29" name="그림 28">
                <a:extLst>
                  <a:ext uri="{FF2B5EF4-FFF2-40B4-BE49-F238E27FC236}">
                    <a16:creationId xmlns:a16="http://schemas.microsoft.com/office/drawing/2014/main" id="{16527416-33B8-9B03-C0BF-287120B4EF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3647636" y="705261"/>
                <a:ext cx="3616208" cy="2712155"/>
              </a:xfrm>
              <a:prstGeom prst="rect">
                <a:avLst/>
              </a:prstGeom>
            </p:spPr>
          </p:pic>
          <p:sp>
            <p:nvSpPr>
              <p:cNvPr id="5" name="직사각형 4">
                <a:extLst>
                  <a:ext uri="{FF2B5EF4-FFF2-40B4-BE49-F238E27FC236}">
                    <a16:creationId xmlns:a16="http://schemas.microsoft.com/office/drawing/2014/main" id="{4C31FC31-2A79-4332-919C-FB5E1AB2519F}"/>
                  </a:ext>
                </a:extLst>
              </p:cNvPr>
              <p:cNvSpPr/>
              <p:nvPr/>
            </p:nvSpPr>
            <p:spPr>
              <a:xfrm>
                <a:off x="5265683" y="705261"/>
                <a:ext cx="662151" cy="2511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B7373A0-87FB-4054-AD84-74695EF303A3}"/>
                </a:ext>
              </a:extLst>
            </p:cNvPr>
            <p:cNvSpPr txBox="1"/>
            <p:nvPr/>
          </p:nvSpPr>
          <p:spPr>
            <a:xfrm>
              <a:off x="4328906" y="671083"/>
              <a:ext cx="228093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1600" b="1"/>
                <a:t>B. Plasma cholic acid</a:t>
              </a:r>
              <a:endParaRPr kumimoji="1" lang="ko-KR" altLang="en-US" sz="1600" b="1" dirty="0"/>
            </a:p>
          </p:txBody>
        </p:sp>
      </p:grpSp>
      <p:grpSp>
        <p:nvGrpSpPr>
          <p:cNvPr id="12" name="그룹 11">
            <a:extLst>
              <a:ext uri="{FF2B5EF4-FFF2-40B4-BE49-F238E27FC236}">
                <a16:creationId xmlns:a16="http://schemas.microsoft.com/office/drawing/2014/main" id="{BD651F82-489B-4B4C-9D0C-D1EF28AB7DE7}"/>
              </a:ext>
            </a:extLst>
          </p:cNvPr>
          <p:cNvGrpSpPr/>
          <p:nvPr/>
        </p:nvGrpSpPr>
        <p:grpSpPr>
          <a:xfrm>
            <a:off x="8124991" y="699968"/>
            <a:ext cx="3616208" cy="3129390"/>
            <a:chOff x="8124991" y="699968"/>
            <a:chExt cx="3616208" cy="3129390"/>
          </a:xfrm>
        </p:grpSpPr>
        <p:grpSp>
          <p:nvGrpSpPr>
            <p:cNvPr id="11" name="그룹 10">
              <a:extLst>
                <a:ext uri="{FF2B5EF4-FFF2-40B4-BE49-F238E27FC236}">
                  <a16:creationId xmlns:a16="http://schemas.microsoft.com/office/drawing/2014/main" id="{D76B5D43-FDE2-419D-8729-9A04F90F3700}"/>
                </a:ext>
              </a:extLst>
            </p:cNvPr>
            <p:cNvGrpSpPr/>
            <p:nvPr/>
          </p:nvGrpSpPr>
          <p:grpSpPr>
            <a:xfrm>
              <a:off x="8124991" y="712014"/>
              <a:ext cx="3616208" cy="3117344"/>
              <a:chOff x="8124991" y="712014"/>
              <a:chExt cx="3616208" cy="3117344"/>
            </a:xfrm>
          </p:grpSpPr>
          <p:pic>
            <p:nvPicPr>
              <p:cNvPr id="31" name="그림 30">
                <a:extLst>
                  <a:ext uri="{FF2B5EF4-FFF2-40B4-BE49-F238E27FC236}">
                    <a16:creationId xmlns:a16="http://schemas.microsoft.com/office/drawing/2014/main" id="{C4BE74D7-2181-E153-9CD1-F26C7255F2C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8124991" y="716846"/>
                <a:ext cx="3616208" cy="3112512"/>
              </a:xfrm>
              <a:prstGeom prst="rect">
                <a:avLst/>
              </a:prstGeom>
            </p:spPr>
          </p:pic>
          <p:sp>
            <p:nvSpPr>
              <p:cNvPr id="8" name="직사각형 7">
                <a:extLst>
                  <a:ext uri="{FF2B5EF4-FFF2-40B4-BE49-F238E27FC236}">
                    <a16:creationId xmlns:a16="http://schemas.microsoft.com/office/drawing/2014/main" id="{DE7F7046-EBF8-4722-9CE5-4338B6EE631F}"/>
                  </a:ext>
                </a:extLst>
              </p:cNvPr>
              <p:cNvSpPr/>
              <p:nvPr/>
            </p:nvSpPr>
            <p:spPr>
              <a:xfrm>
                <a:off x="9743090" y="712014"/>
                <a:ext cx="609600" cy="3385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A49C084-1CAB-4319-BF1B-8CC165466AE5}"/>
                </a:ext>
              </a:extLst>
            </p:cNvPr>
            <p:cNvSpPr txBox="1"/>
            <p:nvPr/>
          </p:nvSpPr>
          <p:spPr>
            <a:xfrm>
              <a:off x="8316226" y="699968"/>
              <a:ext cx="3045457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1600" b="1"/>
                <a:t>C. Plasma deoxycholic acid</a:t>
              </a:r>
              <a:endParaRPr kumimoji="1" lang="ko-KR" altLang="en-US" sz="1600" b="1" dirty="0"/>
            </a:p>
          </p:txBody>
        </p:sp>
      </p:grp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51AC14F4-2EA0-4226-99EC-9506C3C827AC}"/>
              </a:ext>
            </a:extLst>
          </p:cNvPr>
          <p:cNvSpPr/>
          <p:nvPr/>
        </p:nvSpPr>
        <p:spPr>
          <a:xfrm>
            <a:off x="1891862" y="4059620"/>
            <a:ext cx="536028" cy="2601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A646A2D-ABED-4707-AF0B-D3275C166C7A}"/>
              </a:ext>
            </a:extLst>
          </p:cNvPr>
          <p:cNvSpPr txBox="1"/>
          <p:nvPr/>
        </p:nvSpPr>
        <p:spPr>
          <a:xfrm>
            <a:off x="420157" y="3890343"/>
            <a:ext cx="326897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ko-KR" sz="1600" b="1"/>
              <a:t>D. Plasma glycoholic acid  </a:t>
            </a:r>
            <a:endParaRPr kumimoji="1" lang="ko-KR" altLang="en-US" sz="1600" b="1" dirty="0"/>
          </a:p>
        </p:txBody>
      </p:sp>
      <p:grpSp>
        <p:nvGrpSpPr>
          <p:cNvPr id="20" name="그룹 19">
            <a:extLst>
              <a:ext uri="{FF2B5EF4-FFF2-40B4-BE49-F238E27FC236}">
                <a16:creationId xmlns:a16="http://schemas.microsoft.com/office/drawing/2014/main" id="{4D1EB3B2-4FB3-434B-ACF4-DB04813F640F}"/>
              </a:ext>
            </a:extLst>
          </p:cNvPr>
          <p:cNvGrpSpPr/>
          <p:nvPr/>
        </p:nvGrpSpPr>
        <p:grpSpPr>
          <a:xfrm>
            <a:off x="4098957" y="3901311"/>
            <a:ext cx="4094197" cy="3051766"/>
            <a:chOff x="4098957" y="3901311"/>
            <a:chExt cx="4094197" cy="3051766"/>
          </a:xfrm>
        </p:grpSpPr>
        <p:grpSp>
          <p:nvGrpSpPr>
            <p:cNvPr id="19" name="그룹 18">
              <a:extLst>
                <a:ext uri="{FF2B5EF4-FFF2-40B4-BE49-F238E27FC236}">
                  <a16:creationId xmlns:a16="http://schemas.microsoft.com/office/drawing/2014/main" id="{E9019F69-1CA8-4AB4-99C9-BCFC1F8C1F94}"/>
                </a:ext>
              </a:extLst>
            </p:cNvPr>
            <p:cNvGrpSpPr/>
            <p:nvPr/>
          </p:nvGrpSpPr>
          <p:grpSpPr>
            <a:xfrm>
              <a:off x="4098957" y="3923426"/>
              <a:ext cx="3616208" cy="3029651"/>
              <a:chOff x="4098957" y="3923426"/>
              <a:chExt cx="3616208" cy="3029651"/>
            </a:xfrm>
          </p:grpSpPr>
          <p:pic>
            <p:nvPicPr>
              <p:cNvPr id="33" name="그림 32">
                <a:extLst>
                  <a:ext uri="{FF2B5EF4-FFF2-40B4-BE49-F238E27FC236}">
                    <a16:creationId xmlns:a16="http://schemas.microsoft.com/office/drawing/2014/main" id="{0D2819EB-BFAE-219C-634C-3CE53906586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4098957" y="3923426"/>
                <a:ext cx="3616208" cy="3029651"/>
              </a:xfrm>
              <a:prstGeom prst="rect">
                <a:avLst/>
              </a:prstGeom>
            </p:spPr>
          </p:pic>
          <p:sp>
            <p:nvSpPr>
              <p:cNvPr id="18" name="직사각형 17">
                <a:extLst>
                  <a:ext uri="{FF2B5EF4-FFF2-40B4-BE49-F238E27FC236}">
                    <a16:creationId xmlns:a16="http://schemas.microsoft.com/office/drawing/2014/main" id="{05498E53-7AAA-4330-9BDC-39B2C4F5AF4D}"/>
                  </a:ext>
                </a:extLst>
              </p:cNvPr>
              <p:cNvSpPr/>
              <p:nvPr/>
            </p:nvSpPr>
            <p:spPr>
              <a:xfrm>
                <a:off x="5717004" y="3950795"/>
                <a:ext cx="662151" cy="21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97D26FA-C417-46C9-8D31-224873CE8535}"/>
                </a:ext>
              </a:extLst>
            </p:cNvPr>
            <p:cNvSpPr txBox="1"/>
            <p:nvPr/>
          </p:nvSpPr>
          <p:spPr>
            <a:xfrm>
              <a:off x="4248013" y="3901311"/>
              <a:ext cx="394514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1600" b="1"/>
                <a:t>E. Plasma glycochenodeoxycholic acid </a:t>
              </a:r>
              <a:endParaRPr kumimoji="1" lang="ko-KR" altLang="en-US" sz="1600" b="1" dirty="0"/>
            </a:p>
          </p:txBody>
        </p:sp>
      </p:grpSp>
      <p:grpSp>
        <p:nvGrpSpPr>
          <p:cNvPr id="24" name="그룹 23">
            <a:extLst>
              <a:ext uri="{FF2B5EF4-FFF2-40B4-BE49-F238E27FC236}">
                <a16:creationId xmlns:a16="http://schemas.microsoft.com/office/drawing/2014/main" id="{965265C6-79A1-4359-AB13-F510911C1956}"/>
              </a:ext>
            </a:extLst>
          </p:cNvPr>
          <p:cNvGrpSpPr/>
          <p:nvPr/>
        </p:nvGrpSpPr>
        <p:grpSpPr>
          <a:xfrm>
            <a:off x="8124991" y="3846236"/>
            <a:ext cx="3945141" cy="3011764"/>
            <a:chOff x="8124991" y="3846236"/>
            <a:chExt cx="3945141" cy="3011764"/>
          </a:xfrm>
        </p:grpSpPr>
        <p:grpSp>
          <p:nvGrpSpPr>
            <p:cNvPr id="23" name="그룹 22">
              <a:extLst>
                <a:ext uri="{FF2B5EF4-FFF2-40B4-BE49-F238E27FC236}">
                  <a16:creationId xmlns:a16="http://schemas.microsoft.com/office/drawing/2014/main" id="{CACEBA8E-95AE-4917-9C12-BACA07259A4C}"/>
                </a:ext>
              </a:extLst>
            </p:cNvPr>
            <p:cNvGrpSpPr/>
            <p:nvPr/>
          </p:nvGrpSpPr>
          <p:grpSpPr>
            <a:xfrm>
              <a:off x="8124991" y="3878317"/>
              <a:ext cx="3631596" cy="2979683"/>
              <a:chOff x="8124991" y="3878317"/>
              <a:chExt cx="3631596" cy="2979683"/>
            </a:xfrm>
          </p:grpSpPr>
          <p:pic>
            <p:nvPicPr>
              <p:cNvPr id="26" name="그림 25">
                <a:extLst>
                  <a:ext uri="{FF2B5EF4-FFF2-40B4-BE49-F238E27FC236}">
                    <a16:creationId xmlns:a16="http://schemas.microsoft.com/office/drawing/2014/main" id="{84E2E4F0-1965-1F30-BC25-E6DAADDE93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8124991" y="3878317"/>
                <a:ext cx="3631596" cy="2979683"/>
              </a:xfrm>
              <a:prstGeom prst="rect">
                <a:avLst/>
              </a:prstGeom>
            </p:spPr>
          </p:pic>
          <p:sp>
            <p:nvSpPr>
              <p:cNvPr id="22" name="직사각형 21">
                <a:extLst>
                  <a:ext uri="{FF2B5EF4-FFF2-40B4-BE49-F238E27FC236}">
                    <a16:creationId xmlns:a16="http://schemas.microsoft.com/office/drawing/2014/main" id="{4888761F-DC6F-4DB5-81E4-7CEC8EDFA6DA}"/>
                  </a:ext>
                </a:extLst>
              </p:cNvPr>
              <p:cNvSpPr/>
              <p:nvPr/>
            </p:nvSpPr>
            <p:spPr>
              <a:xfrm>
                <a:off x="9838954" y="3950795"/>
                <a:ext cx="461184" cy="21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460DD57-DC89-4F4D-A19D-A66729098E28}"/>
                </a:ext>
              </a:extLst>
            </p:cNvPr>
            <p:cNvSpPr txBox="1"/>
            <p:nvPr/>
          </p:nvSpPr>
          <p:spPr>
            <a:xfrm>
              <a:off x="8356416" y="3846236"/>
              <a:ext cx="3713716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1600" b="1"/>
                <a:t>F. Plasma lithocholic acid  </a:t>
              </a:r>
              <a:endParaRPr kumimoji="1" lang="ko-KR" altLang="en-US" sz="16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0163087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34EB79C7-927B-86C8-401D-7B2ECF8A38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5195373"/>
              </p:ext>
            </p:extLst>
          </p:nvPr>
        </p:nvGraphicFramePr>
        <p:xfrm>
          <a:off x="160719" y="872598"/>
          <a:ext cx="3276164" cy="226306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217612">
                  <a:extLst>
                    <a:ext uri="{9D8B030D-6E8A-4147-A177-3AD203B41FA5}">
                      <a16:colId xmlns:a16="http://schemas.microsoft.com/office/drawing/2014/main" val="2515213848"/>
                    </a:ext>
                  </a:extLst>
                </a:gridCol>
                <a:gridCol w="667815">
                  <a:extLst>
                    <a:ext uri="{9D8B030D-6E8A-4147-A177-3AD203B41FA5}">
                      <a16:colId xmlns:a16="http://schemas.microsoft.com/office/drawing/2014/main" val="1915828068"/>
                    </a:ext>
                  </a:extLst>
                </a:gridCol>
                <a:gridCol w="707473">
                  <a:extLst>
                    <a:ext uri="{9D8B030D-6E8A-4147-A177-3AD203B41FA5}">
                      <a16:colId xmlns:a16="http://schemas.microsoft.com/office/drawing/2014/main" val="2547297687"/>
                    </a:ext>
                  </a:extLst>
                </a:gridCol>
                <a:gridCol w="683264">
                  <a:extLst>
                    <a:ext uri="{9D8B030D-6E8A-4147-A177-3AD203B41FA5}">
                      <a16:colId xmlns:a16="http://schemas.microsoft.com/office/drawing/2014/main" val="449419578"/>
                    </a:ext>
                  </a:extLst>
                </a:gridCol>
              </a:tblGrid>
              <a:tr h="150871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Compound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reatment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Fold_Change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p_value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101725"/>
                  </a:ext>
                </a:extLst>
              </a:tr>
              <a:tr h="150871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Acetic aci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Dulaglutid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65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248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7307404"/>
                  </a:ext>
                </a:extLst>
              </a:tr>
              <a:tr h="150871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Acetic aci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Empagliflozi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16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129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11894996"/>
                  </a:ext>
                </a:extLst>
              </a:tr>
              <a:tr h="150871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Propionic aci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Dulaglutid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68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26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750810676"/>
                  </a:ext>
                </a:extLst>
              </a:tr>
              <a:tr h="150871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Propionic aci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Empagliflozi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04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149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96500399"/>
                  </a:ext>
                </a:extLst>
              </a:tr>
              <a:tr h="150871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Butyric aci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Dulaglutid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64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246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66632419"/>
                  </a:ext>
                </a:extLst>
              </a:tr>
              <a:tr h="150871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Butyric aci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Empagliflozi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20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139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69587864"/>
                  </a:ext>
                </a:extLst>
              </a:tr>
              <a:tr h="150871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sobutyric aci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Dulaglutid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7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351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98657901"/>
                  </a:ext>
                </a:extLst>
              </a:tr>
              <a:tr h="150871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sobutyric aci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Empagliflozi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80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1259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21103862"/>
                  </a:ext>
                </a:extLst>
              </a:tr>
              <a:tr h="150871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-Methylbutyric aci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Dulaglutid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2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297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26267158"/>
                  </a:ext>
                </a:extLst>
              </a:tr>
              <a:tr h="150871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-Methylbutyric aci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Empagliflozi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94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1283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39362499"/>
                  </a:ext>
                </a:extLst>
              </a:tr>
              <a:tr h="150871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sovaleric aci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Dulaglutid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0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25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01693235"/>
                  </a:ext>
                </a:extLst>
              </a:tr>
              <a:tr h="150871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sovaleric aci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Empagliflozi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88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14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51744272"/>
                  </a:ext>
                </a:extLst>
              </a:tr>
              <a:tr h="150871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Valeric aci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Dulaglutid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5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224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89665437"/>
                  </a:ext>
                </a:extLst>
              </a:tr>
              <a:tr h="150871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Valeric aci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Empagliflozi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24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167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92665067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7535F2B8-CA22-4224-9899-FEEFBE7D488E}"/>
              </a:ext>
            </a:extLst>
          </p:cNvPr>
          <p:cNvSpPr txBox="1"/>
          <p:nvPr/>
        </p:nvSpPr>
        <p:spPr>
          <a:xfrm>
            <a:off x="75866" y="52631"/>
            <a:ext cx="17300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sz="2000" b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ko-KR" altLang="en-US" sz="20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kumimoji="1" lang="ko-Kore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2C0DD3D-DBE4-457D-892C-4F6BBDB0BD15}"/>
              </a:ext>
            </a:extLst>
          </p:cNvPr>
          <p:cNvSpPr txBox="1"/>
          <p:nvPr/>
        </p:nvSpPr>
        <p:spPr>
          <a:xfrm>
            <a:off x="75866" y="516139"/>
            <a:ext cx="353219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ko-KR" sz="1600" b="1"/>
              <a:t>A. Types of short chain fatty acids </a:t>
            </a:r>
            <a:endParaRPr kumimoji="1" lang="ko-KR" altLang="en-US" sz="1600" b="1" dirty="0"/>
          </a:p>
        </p:txBody>
      </p:sp>
      <p:grpSp>
        <p:nvGrpSpPr>
          <p:cNvPr id="6" name="그룹 5">
            <a:extLst>
              <a:ext uri="{FF2B5EF4-FFF2-40B4-BE49-F238E27FC236}">
                <a16:creationId xmlns:a16="http://schemas.microsoft.com/office/drawing/2014/main" id="{443F2B41-4D9B-4A71-B994-456D87C2F1C6}"/>
              </a:ext>
            </a:extLst>
          </p:cNvPr>
          <p:cNvGrpSpPr/>
          <p:nvPr/>
        </p:nvGrpSpPr>
        <p:grpSpPr>
          <a:xfrm>
            <a:off x="3579738" y="513571"/>
            <a:ext cx="2788126" cy="2914637"/>
            <a:chOff x="3579738" y="513571"/>
            <a:chExt cx="2788126" cy="2914637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9D1DA73-3862-44BA-A7E1-E337DAE91DA4}"/>
                </a:ext>
              </a:extLst>
            </p:cNvPr>
            <p:cNvSpPr txBox="1"/>
            <p:nvPr/>
          </p:nvSpPr>
          <p:spPr>
            <a:xfrm>
              <a:off x="3699402" y="513571"/>
              <a:ext cx="209977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1600" b="1"/>
                <a:t>B. Acetic acid </a:t>
              </a:r>
              <a:endParaRPr kumimoji="1" lang="ko-KR" altLang="en-US" sz="1600" b="1" dirty="0"/>
            </a:p>
          </p:txBody>
        </p:sp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DFAB676C-00B9-4A45-98DB-44F94795BBAE}"/>
                </a:ext>
              </a:extLst>
            </p:cNvPr>
            <p:cNvGrpSpPr/>
            <p:nvPr/>
          </p:nvGrpSpPr>
          <p:grpSpPr>
            <a:xfrm>
              <a:off x="3579738" y="811133"/>
              <a:ext cx="2788126" cy="2617075"/>
              <a:chOff x="3579738" y="811133"/>
              <a:chExt cx="2788126" cy="2617075"/>
            </a:xfrm>
          </p:grpSpPr>
          <p:pic>
            <p:nvPicPr>
              <p:cNvPr id="23" name="그림 22">
                <a:extLst>
                  <a:ext uri="{FF2B5EF4-FFF2-40B4-BE49-F238E27FC236}">
                    <a16:creationId xmlns:a16="http://schemas.microsoft.com/office/drawing/2014/main" id="{A32D8004-57B7-9D80-FB7B-28C19CC061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3579738" y="811133"/>
                <a:ext cx="2788126" cy="2617075"/>
              </a:xfrm>
              <a:prstGeom prst="rect">
                <a:avLst/>
              </a:prstGeom>
            </p:spPr>
          </p:pic>
          <p:sp>
            <p:nvSpPr>
              <p:cNvPr id="4" name="직사각형 3">
                <a:extLst>
                  <a:ext uri="{FF2B5EF4-FFF2-40B4-BE49-F238E27FC236}">
                    <a16:creationId xmlns:a16="http://schemas.microsoft.com/office/drawing/2014/main" id="{A04561D2-96D9-4090-8D2F-51239943629A}"/>
                  </a:ext>
                </a:extLst>
              </p:cNvPr>
              <p:cNvSpPr/>
              <p:nvPr/>
            </p:nvSpPr>
            <p:spPr>
              <a:xfrm>
                <a:off x="4729655" y="854693"/>
                <a:ext cx="735724" cy="1648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</p:grpSp>
      <p:grpSp>
        <p:nvGrpSpPr>
          <p:cNvPr id="10" name="그룹 9">
            <a:extLst>
              <a:ext uri="{FF2B5EF4-FFF2-40B4-BE49-F238E27FC236}">
                <a16:creationId xmlns:a16="http://schemas.microsoft.com/office/drawing/2014/main" id="{9F340644-861E-4902-8622-E3B72418FDAE}"/>
              </a:ext>
            </a:extLst>
          </p:cNvPr>
          <p:cNvGrpSpPr/>
          <p:nvPr/>
        </p:nvGrpSpPr>
        <p:grpSpPr>
          <a:xfrm>
            <a:off x="6282889" y="534044"/>
            <a:ext cx="2788126" cy="2894163"/>
            <a:chOff x="6282889" y="534044"/>
            <a:chExt cx="2788126" cy="2894163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7076FBF-5EC4-469C-B5CB-C8A119DA3DBD}"/>
                </a:ext>
              </a:extLst>
            </p:cNvPr>
            <p:cNvSpPr txBox="1"/>
            <p:nvPr/>
          </p:nvSpPr>
          <p:spPr>
            <a:xfrm>
              <a:off x="6425477" y="534044"/>
              <a:ext cx="209977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1600" b="1"/>
                <a:t>C. Propionic acid</a:t>
              </a:r>
              <a:endParaRPr kumimoji="1" lang="ko-KR" altLang="en-US" sz="1600" b="1" dirty="0"/>
            </a:p>
          </p:txBody>
        </p:sp>
        <p:grpSp>
          <p:nvGrpSpPr>
            <p:cNvPr id="9" name="그룹 8">
              <a:extLst>
                <a:ext uri="{FF2B5EF4-FFF2-40B4-BE49-F238E27FC236}">
                  <a16:creationId xmlns:a16="http://schemas.microsoft.com/office/drawing/2014/main" id="{D3C746A2-1A5F-4ACA-9563-F136BB532C71}"/>
                </a:ext>
              </a:extLst>
            </p:cNvPr>
            <p:cNvGrpSpPr/>
            <p:nvPr/>
          </p:nvGrpSpPr>
          <p:grpSpPr>
            <a:xfrm>
              <a:off x="6282889" y="903404"/>
              <a:ext cx="2788126" cy="2524803"/>
              <a:chOff x="6282889" y="903404"/>
              <a:chExt cx="2788126" cy="2524803"/>
            </a:xfrm>
          </p:grpSpPr>
          <p:pic>
            <p:nvPicPr>
              <p:cNvPr id="31" name="그림 30">
                <a:extLst>
                  <a:ext uri="{FF2B5EF4-FFF2-40B4-BE49-F238E27FC236}">
                    <a16:creationId xmlns:a16="http://schemas.microsoft.com/office/drawing/2014/main" id="{BB5CF82D-181E-E31C-68E4-459B75AC746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6282889" y="903404"/>
                <a:ext cx="2788126" cy="2524803"/>
              </a:xfrm>
              <a:prstGeom prst="rect">
                <a:avLst/>
              </a:prstGeom>
            </p:spPr>
          </p:pic>
          <p:sp>
            <p:nvSpPr>
              <p:cNvPr id="7" name="직사각형 6">
                <a:extLst>
                  <a:ext uri="{FF2B5EF4-FFF2-40B4-BE49-F238E27FC236}">
                    <a16:creationId xmlns:a16="http://schemas.microsoft.com/office/drawing/2014/main" id="{4F139416-92F4-470F-AF56-8745CD260D7B}"/>
                  </a:ext>
                </a:extLst>
              </p:cNvPr>
              <p:cNvSpPr/>
              <p:nvPr/>
            </p:nvSpPr>
            <p:spPr>
              <a:xfrm>
                <a:off x="7304690" y="937098"/>
                <a:ext cx="998482" cy="18750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</p:grpSp>
      <p:grpSp>
        <p:nvGrpSpPr>
          <p:cNvPr id="17" name="그룹 16">
            <a:extLst>
              <a:ext uri="{FF2B5EF4-FFF2-40B4-BE49-F238E27FC236}">
                <a16:creationId xmlns:a16="http://schemas.microsoft.com/office/drawing/2014/main" id="{C0243FA0-B7F9-4CA6-A9C6-96471F12F97E}"/>
              </a:ext>
            </a:extLst>
          </p:cNvPr>
          <p:cNvGrpSpPr/>
          <p:nvPr/>
        </p:nvGrpSpPr>
        <p:grpSpPr>
          <a:xfrm>
            <a:off x="8986040" y="520821"/>
            <a:ext cx="2788126" cy="2907384"/>
            <a:chOff x="8986040" y="520821"/>
            <a:chExt cx="2788126" cy="2907384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EB109F6-49B6-4E62-B27E-A61238058941}"/>
                </a:ext>
              </a:extLst>
            </p:cNvPr>
            <p:cNvSpPr txBox="1"/>
            <p:nvPr/>
          </p:nvSpPr>
          <p:spPr>
            <a:xfrm>
              <a:off x="9106540" y="520821"/>
              <a:ext cx="209977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1600" b="1"/>
                <a:t>D. Butyric acid</a:t>
              </a:r>
              <a:endParaRPr kumimoji="1" lang="ko-KR" altLang="en-US" sz="1600" b="1" dirty="0"/>
            </a:p>
          </p:txBody>
        </p:sp>
        <p:grpSp>
          <p:nvGrpSpPr>
            <p:cNvPr id="16" name="그룹 15">
              <a:extLst>
                <a:ext uri="{FF2B5EF4-FFF2-40B4-BE49-F238E27FC236}">
                  <a16:creationId xmlns:a16="http://schemas.microsoft.com/office/drawing/2014/main" id="{D9B551A5-8266-408A-A464-581D08093493}"/>
                </a:ext>
              </a:extLst>
            </p:cNvPr>
            <p:cNvGrpSpPr/>
            <p:nvPr/>
          </p:nvGrpSpPr>
          <p:grpSpPr>
            <a:xfrm>
              <a:off x="8986040" y="903402"/>
              <a:ext cx="2788126" cy="2524803"/>
              <a:chOff x="8986040" y="903402"/>
              <a:chExt cx="2788126" cy="2524803"/>
            </a:xfrm>
          </p:grpSpPr>
          <p:pic>
            <p:nvPicPr>
              <p:cNvPr id="25" name="그림 24">
                <a:extLst>
                  <a:ext uri="{FF2B5EF4-FFF2-40B4-BE49-F238E27FC236}">
                    <a16:creationId xmlns:a16="http://schemas.microsoft.com/office/drawing/2014/main" id="{DC26984F-2D13-E1CB-4B45-C4DD0700089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8986040" y="903402"/>
                <a:ext cx="2788126" cy="2524803"/>
              </a:xfrm>
              <a:prstGeom prst="rect">
                <a:avLst/>
              </a:prstGeom>
            </p:spPr>
          </p:pic>
          <p:sp>
            <p:nvSpPr>
              <p:cNvPr id="15" name="직사각형 14">
                <a:extLst>
                  <a:ext uri="{FF2B5EF4-FFF2-40B4-BE49-F238E27FC236}">
                    <a16:creationId xmlns:a16="http://schemas.microsoft.com/office/drawing/2014/main" id="{5A7491B6-3CA9-4FDC-B2EB-73B865908AC9}"/>
                  </a:ext>
                </a:extLst>
              </p:cNvPr>
              <p:cNvSpPr/>
              <p:nvPr/>
            </p:nvSpPr>
            <p:spPr>
              <a:xfrm>
                <a:off x="10068910" y="937098"/>
                <a:ext cx="777766" cy="18750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</p:grpSp>
      <p:grpSp>
        <p:nvGrpSpPr>
          <p:cNvPr id="20" name="그룹 19">
            <a:extLst>
              <a:ext uri="{FF2B5EF4-FFF2-40B4-BE49-F238E27FC236}">
                <a16:creationId xmlns:a16="http://schemas.microsoft.com/office/drawing/2014/main" id="{D98688EF-5E6C-475B-BFCA-5046A3A799D9}"/>
              </a:ext>
            </a:extLst>
          </p:cNvPr>
          <p:cNvGrpSpPr/>
          <p:nvPr/>
        </p:nvGrpSpPr>
        <p:grpSpPr>
          <a:xfrm>
            <a:off x="145970" y="3610141"/>
            <a:ext cx="2788126" cy="2811680"/>
            <a:chOff x="145970" y="3610141"/>
            <a:chExt cx="2788126" cy="2811680"/>
          </a:xfrm>
        </p:grpSpPr>
        <p:pic>
          <p:nvPicPr>
            <p:cNvPr id="27" name="그림 26">
              <a:extLst>
                <a:ext uri="{FF2B5EF4-FFF2-40B4-BE49-F238E27FC236}">
                  <a16:creationId xmlns:a16="http://schemas.microsoft.com/office/drawing/2014/main" id="{EEAC32B2-9739-0E55-BD49-8F439084F1A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45970" y="3939567"/>
              <a:ext cx="2788126" cy="2482254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3BAD1C9-654E-4FD0-91F6-C9E6084F20E1}"/>
                </a:ext>
              </a:extLst>
            </p:cNvPr>
            <p:cNvSpPr txBox="1"/>
            <p:nvPr/>
          </p:nvSpPr>
          <p:spPr>
            <a:xfrm>
              <a:off x="327364" y="3610141"/>
              <a:ext cx="209977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1600" b="1"/>
                <a:t>E. Isobutyric acid</a:t>
              </a:r>
              <a:endParaRPr kumimoji="1" lang="ko-KR" altLang="en-US" sz="1600" b="1" dirty="0"/>
            </a:p>
          </p:txBody>
        </p:sp>
        <p:sp>
          <p:nvSpPr>
            <p:cNvPr id="19" name="직사각형 18">
              <a:extLst>
                <a:ext uri="{FF2B5EF4-FFF2-40B4-BE49-F238E27FC236}">
                  <a16:creationId xmlns:a16="http://schemas.microsoft.com/office/drawing/2014/main" id="{580E4EC8-6D59-47FE-A4A6-EB82F605E449}"/>
                </a:ext>
              </a:extLst>
            </p:cNvPr>
            <p:cNvSpPr/>
            <p:nvPr/>
          </p:nvSpPr>
          <p:spPr>
            <a:xfrm>
              <a:off x="1166648" y="3939567"/>
              <a:ext cx="924911" cy="2120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ADE68268-EF29-40D2-95B8-5A0A5D511627}"/>
              </a:ext>
            </a:extLst>
          </p:cNvPr>
          <p:cNvSpPr txBox="1"/>
          <p:nvPr/>
        </p:nvSpPr>
        <p:spPr>
          <a:xfrm>
            <a:off x="3307653" y="3622996"/>
            <a:ext cx="269064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ko-KR" sz="1600" b="1"/>
              <a:t>F. 2-Methylbutyric acid</a:t>
            </a:r>
            <a:endParaRPr kumimoji="1" lang="ko-KR" altLang="en-US" sz="1600" b="1" dirty="0"/>
          </a:p>
        </p:txBody>
      </p:sp>
      <p:grpSp>
        <p:nvGrpSpPr>
          <p:cNvPr id="28" name="그룹 27">
            <a:extLst>
              <a:ext uri="{FF2B5EF4-FFF2-40B4-BE49-F238E27FC236}">
                <a16:creationId xmlns:a16="http://schemas.microsoft.com/office/drawing/2014/main" id="{82012080-3DB9-4382-9A62-AF61D7E184B5}"/>
              </a:ext>
            </a:extLst>
          </p:cNvPr>
          <p:cNvGrpSpPr/>
          <p:nvPr/>
        </p:nvGrpSpPr>
        <p:grpSpPr>
          <a:xfrm>
            <a:off x="3120985" y="3894307"/>
            <a:ext cx="2788126" cy="2527513"/>
            <a:chOff x="3120985" y="3894307"/>
            <a:chExt cx="2788126" cy="2527513"/>
          </a:xfrm>
        </p:grpSpPr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7D89691A-8A5A-C0D6-0734-AE1532C98AE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120985" y="3894307"/>
              <a:ext cx="2788126" cy="2527513"/>
            </a:xfrm>
            <a:prstGeom prst="rect">
              <a:avLst/>
            </a:prstGeom>
          </p:spPr>
        </p:pic>
        <p:sp>
          <p:nvSpPr>
            <p:cNvPr id="24" name="직사각형 23">
              <a:extLst>
                <a:ext uri="{FF2B5EF4-FFF2-40B4-BE49-F238E27FC236}">
                  <a16:creationId xmlns:a16="http://schemas.microsoft.com/office/drawing/2014/main" id="{4FF9C042-1513-451F-840B-9AC9FB5F34EC}"/>
                </a:ext>
              </a:extLst>
            </p:cNvPr>
            <p:cNvSpPr/>
            <p:nvPr/>
          </p:nvSpPr>
          <p:spPr>
            <a:xfrm>
              <a:off x="4068918" y="3948695"/>
              <a:ext cx="1168118" cy="20289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36" name="그룹 35">
            <a:extLst>
              <a:ext uri="{FF2B5EF4-FFF2-40B4-BE49-F238E27FC236}">
                <a16:creationId xmlns:a16="http://schemas.microsoft.com/office/drawing/2014/main" id="{CE05CF42-2D4E-46EA-B521-585C9EC5B613}"/>
              </a:ext>
            </a:extLst>
          </p:cNvPr>
          <p:cNvGrpSpPr/>
          <p:nvPr/>
        </p:nvGrpSpPr>
        <p:grpSpPr>
          <a:xfrm>
            <a:off x="6096000" y="3614069"/>
            <a:ext cx="2788126" cy="2807751"/>
            <a:chOff x="6096000" y="3614069"/>
            <a:chExt cx="2788126" cy="2807751"/>
          </a:xfrm>
        </p:grpSpPr>
        <p:grpSp>
          <p:nvGrpSpPr>
            <p:cNvPr id="35" name="그룹 34">
              <a:extLst>
                <a:ext uri="{FF2B5EF4-FFF2-40B4-BE49-F238E27FC236}">
                  <a16:creationId xmlns:a16="http://schemas.microsoft.com/office/drawing/2014/main" id="{FCA3003A-1735-47DB-BA79-DBE9E5BBF8A1}"/>
                </a:ext>
              </a:extLst>
            </p:cNvPr>
            <p:cNvGrpSpPr/>
            <p:nvPr/>
          </p:nvGrpSpPr>
          <p:grpSpPr>
            <a:xfrm>
              <a:off x="6096000" y="3939567"/>
              <a:ext cx="2788126" cy="2482253"/>
              <a:chOff x="6096000" y="3939567"/>
              <a:chExt cx="2788126" cy="2482253"/>
            </a:xfrm>
          </p:grpSpPr>
          <p:pic>
            <p:nvPicPr>
              <p:cNvPr id="29" name="그림 28">
                <a:extLst>
                  <a:ext uri="{FF2B5EF4-FFF2-40B4-BE49-F238E27FC236}">
                    <a16:creationId xmlns:a16="http://schemas.microsoft.com/office/drawing/2014/main" id="{D18A5F22-1AB2-17E7-8619-E63943545E9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6096000" y="3939567"/>
                <a:ext cx="2788126" cy="2482253"/>
              </a:xfrm>
              <a:prstGeom prst="rect">
                <a:avLst/>
              </a:prstGeom>
            </p:spPr>
          </p:pic>
          <p:sp>
            <p:nvSpPr>
              <p:cNvPr id="32" name="직사각형 31">
                <a:extLst>
                  <a:ext uri="{FF2B5EF4-FFF2-40B4-BE49-F238E27FC236}">
                    <a16:creationId xmlns:a16="http://schemas.microsoft.com/office/drawing/2014/main" id="{75C9381B-075B-49C7-B572-B51F82DBBF48}"/>
                  </a:ext>
                </a:extLst>
              </p:cNvPr>
              <p:cNvSpPr/>
              <p:nvPr/>
            </p:nvSpPr>
            <p:spPr>
              <a:xfrm>
                <a:off x="7178566" y="3961550"/>
                <a:ext cx="882868" cy="19003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EA5C351C-405E-4149-8560-55E379D861AA}"/>
                </a:ext>
              </a:extLst>
            </p:cNvPr>
            <p:cNvSpPr txBox="1"/>
            <p:nvPr/>
          </p:nvSpPr>
          <p:spPr>
            <a:xfrm>
              <a:off x="6282889" y="3614069"/>
              <a:ext cx="209977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1600" b="1"/>
                <a:t>G. Isovaleric acid</a:t>
              </a:r>
              <a:endParaRPr kumimoji="1" lang="ko-KR" altLang="en-US" sz="1600" b="1" dirty="0"/>
            </a:p>
          </p:txBody>
        </p:sp>
      </p:grpSp>
      <p:grpSp>
        <p:nvGrpSpPr>
          <p:cNvPr id="40" name="그룹 39">
            <a:extLst>
              <a:ext uri="{FF2B5EF4-FFF2-40B4-BE49-F238E27FC236}">
                <a16:creationId xmlns:a16="http://schemas.microsoft.com/office/drawing/2014/main" id="{7C5CDA7E-41FC-471C-BAC7-816B197B21FC}"/>
              </a:ext>
            </a:extLst>
          </p:cNvPr>
          <p:cNvGrpSpPr/>
          <p:nvPr/>
        </p:nvGrpSpPr>
        <p:grpSpPr>
          <a:xfrm>
            <a:off x="9071015" y="3620614"/>
            <a:ext cx="2788126" cy="2801205"/>
            <a:chOff x="9071015" y="3620614"/>
            <a:chExt cx="2788126" cy="2801205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D633077-8869-4C56-A180-73B8EBAABE51}"/>
                </a:ext>
              </a:extLst>
            </p:cNvPr>
            <p:cNvSpPr txBox="1"/>
            <p:nvPr/>
          </p:nvSpPr>
          <p:spPr>
            <a:xfrm>
              <a:off x="9168714" y="3620614"/>
              <a:ext cx="209977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1600" b="1"/>
                <a:t>H. Valeric acid</a:t>
              </a:r>
              <a:endParaRPr kumimoji="1" lang="ko-KR" altLang="en-US" sz="1600" b="1" dirty="0"/>
            </a:p>
          </p:txBody>
        </p:sp>
        <p:grpSp>
          <p:nvGrpSpPr>
            <p:cNvPr id="39" name="그룹 38">
              <a:extLst>
                <a:ext uri="{FF2B5EF4-FFF2-40B4-BE49-F238E27FC236}">
                  <a16:creationId xmlns:a16="http://schemas.microsoft.com/office/drawing/2014/main" id="{EDA4DB99-A388-4DA8-8F8E-60224E4F4A78}"/>
                </a:ext>
              </a:extLst>
            </p:cNvPr>
            <p:cNvGrpSpPr/>
            <p:nvPr/>
          </p:nvGrpSpPr>
          <p:grpSpPr>
            <a:xfrm>
              <a:off x="9071015" y="3939567"/>
              <a:ext cx="2788126" cy="2482252"/>
              <a:chOff x="9071015" y="3939567"/>
              <a:chExt cx="2788126" cy="2482252"/>
            </a:xfrm>
          </p:grpSpPr>
          <p:pic>
            <p:nvPicPr>
              <p:cNvPr id="33" name="그림 32">
                <a:extLst>
                  <a:ext uri="{FF2B5EF4-FFF2-40B4-BE49-F238E27FC236}">
                    <a16:creationId xmlns:a16="http://schemas.microsoft.com/office/drawing/2014/main" id="{F4BA3B6D-D742-A8D7-8B3C-8D70811B611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9071015" y="3939567"/>
                <a:ext cx="2788126" cy="2482252"/>
              </a:xfrm>
              <a:prstGeom prst="rect">
                <a:avLst/>
              </a:prstGeom>
            </p:spPr>
          </p:pic>
          <p:sp>
            <p:nvSpPr>
              <p:cNvPr id="38" name="직사각형 37">
                <a:extLst>
                  <a:ext uri="{FF2B5EF4-FFF2-40B4-BE49-F238E27FC236}">
                    <a16:creationId xmlns:a16="http://schemas.microsoft.com/office/drawing/2014/main" id="{63F06E81-DAD5-46A3-B54B-3CE918BF92FE}"/>
                  </a:ext>
                </a:extLst>
              </p:cNvPr>
              <p:cNvSpPr/>
              <p:nvPr/>
            </p:nvSpPr>
            <p:spPr>
              <a:xfrm>
                <a:off x="10156426" y="3948695"/>
                <a:ext cx="690250" cy="20288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382232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D27A5D34-5B59-7D9D-290E-CC109F60E7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47621615"/>
              </p:ext>
            </p:extLst>
          </p:nvPr>
        </p:nvGraphicFramePr>
        <p:xfrm>
          <a:off x="31261" y="1914953"/>
          <a:ext cx="2943646" cy="197358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787395">
                  <a:extLst>
                    <a:ext uri="{9D8B030D-6E8A-4147-A177-3AD203B41FA5}">
                      <a16:colId xmlns:a16="http://schemas.microsoft.com/office/drawing/2014/main" val="334726076"/>
                    </a:ext>
                  </a:extLst>
                </a:gridCol>
                <a:gridCol w="702598">
                  <a:extLst>
                    <a:ext uri="{9D8B030D-6E8A-4147-A177-3AD203B41FA5}">
                      <a16:colId xmlns:a16="http://schemas.microsoft.com/office/drawing/2014/main" val="2224691802"/>
                    </a:ext>
                  </a:extLst>
                </a:gridCol>
                <a:gridCol w="717741">
                  <a:extLst>
                    <a:ext uri="{9D8B030D-6E8A-4147-A177-3AD203B41FA5}">
                      <a16:colId xmlns:a16="http://schemas.microsoft.com/office/drawing/2014/main" val="3543648859"/>
                    </a:ext>
                  </a:extLst>
                </a:gridCol>
                <a:gridCol w="735912">
                  <a:extLst>
                    <a:ext uri="{9D8B030D-6E8A-4147-A177-3AD203B41FA5}">
                      <a16:colId xmlns:a16="http://schemas.microsoft.com/office/drawing/2014/main" val="2773117744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ompou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Treatmen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Fold_Chang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p_valu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0957704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euc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Dulaglutid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98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637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40815176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Leuc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Empaglifloz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97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22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83274804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Isoleuc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Dulaglutid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1.02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573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03009259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Isoleuc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Empaglifloz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93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040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7152838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Val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Dulaglutid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1.12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140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748951666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Val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Empaglifloz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1.24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012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80666193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2-Aminobutyric aci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Dulaglutid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1.0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0.8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48849398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2-Aminobutyric aci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Empaglifloz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>
                          <a:solidFill>
                            <a:srgbClr val="000000"/>
                          </a:solidFill>
                          <a:effectLst/>
                        </a:rPr>
                        <a:t>1.00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ko-KR" sz="8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90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99225382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7F2EE636-3A64-4F1E-B178-3FF8476C74F1}"/>
              </a:ext>
            </a:extLst>
          </p:cNvPr>
          <p:cNvSpPr txBox="1"/>
          <p:nvPr/>
        </p:nvSpPr>
        <p:spPr>
          <a:xfrm>
            <a:off x="75866" y="52631"/>
            <a:ext cx="17300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sz="2000" b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ko-KR" altLang="en-US" sz="20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kumimoji="1" lang="ko-Kore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CBC1BB2-A070-43DA-8119-934B7202208F}"/>
              </a:ext>
            </a:extLst>
          </p:cNvPr>
          <p:cNvSpPr txBox="1"/>
          <p:nvPr/>
        </p:nvSpPr>
        <p:spPr>
          <a:xfrm>
            <a:off x="75866" y="1330178"/>
            <a:ext cx="2343949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ko-KR" sz="1600" b="1"/>
              <a:t>A. Types of branched     </a:t>
            </a:r>
          </a:p>
          <a:p>
            <a:r>
              <a:rPr kumimoji="1" lang="en-US" altLang="ko-KR" sz="1600" b="1"/>
              <a:t>    chain amino acids </a:t>
            </a:r>
            <a:endParaRPr kumimoji="1" lang="ko-KR" altLang="en-US" sz="1600" b="1" dirty="0"/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55E76CC1-BDBA-417D-9442-AFC5F7FC6B14}"/>
              </a:ext>
            </a:extLst>
          </p:cNvPr>
          <p:cNvGrpSpPr/>
          <p:nvPr/>
        </p:nvGrpSpPr>
        <p:grpSpPr>
          <a:xfrm>
            <a:off x="3446131" y="3533065"/>
            <a:ext cx="3805016" cy="3432037"/>
            <a:chOff x="3345366" y="271225"/>
            <a:chExt cx="3805016" cy="3432037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A823937-99E5-41A1-B494-35AE72F150F6}"/>
                </a:ext>
              </a:extLst>
            </p:cNvPr>
            <p:cNvSpPr txBox="1"/>
            <p:nvPr/>
          </p:nvSpPr>
          <p:spPr>
            <a:xfrm>
              <a:off x="3625600" y="271225"/>
              <a:ext cx="209977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1600" b="1"/>
                <a:t>D. Leuccine </a:t>
              </a:r>
              <a:endParaRPr kumimoji="1" lang="ko-KR" altLang="en-US" sz="1600" b="1" dirty="0"/>
            </a:p>
          </p:txBody>
        </p:sp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014193B6-C19C-4BAF-A23E-FCBAC936F55B}"/>
                </a:ext>
              </a:extLst>
            </p:cNvPr>
            <p:cNvGrpSpPr/>
            <p:nvPr/>
          </p:nvGrpSpPr>
          <p:grpSpPr>
            <a:xfrm>
              <a:off x="3345366" y="428262"/>
              <a:ext cx="3805016" cy="3275000"/>
              <a:chOff x="3345366" y="428262"/>
              <a:chExt cx="3805016" cy="3275000"/>
            </a:xfrm>
          </p:grpSpPr>
          <p:pic>
            <p:nvPicPr>
              <p:cNvPr id="20" name="그림 19">
                <a:extLst>
                  <a:ext uri="{FF2B5EF4-FFF2-40B4-BE49-F238E27FC236}">
                    <a16:creationId xmlns:a16="http://schemas.microsoft.com/office/drawing/2014/main" id="{E7473484-DA2C-9F8D-4B88-562DFFD459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3345366" y="428262"/>
                <a:ext cx="3805016" cy="3275000"/>
              </a:xfrm>
              <a:prstGeom prst="rect">
                <a:avLst/>
              </a:prstGeom>
            </p:spPr>
          </p:pic>
          <p:sp>
            <p:nvSpPr>
              <p:cNvPr id="4" name="직사각형 3">
                <a:extLst>
                  <a:ext uri="{FF2B5EF4-FFF2-40B4-BE49-F238E27FC236}">
                    <a16:creationId xmlns:a16="http://schemas.microsoft.com/office/drawing/2014/main" id="{0EBF0ECF-834D-4605-96BF-1A217881D91D}"/>
                  </a:ext>
                </a:extLst>
              </p:cNvPr>
              <p:cNvSpPr/>
              <p:nvPr/>
            </p:nvSpPr>
            <p:spPr>
              <a:xfrm>
                <a:off x="5040351" y="452741"/>
                <a:ext cx="735981" cy="2163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</p:grpSp>
      <p:grpSp>
        <p:nvGrpSpPr>
          <p:cNvPr id="17" name="그룹 16">
            <a:extLst>
              <a:ext uri="{FF2B5EF4-FFF2-40B4-BE49-F238E27FC236}">
                <a16:creationId xmlns:a16="http://schemas.microsoft.com/office/drawing/2014/main" id="{7DCB49D8-9561-4259-8FF2-90E636A30E54}"/>
              </a:ext>
            </a:extLst>
          </p:cNvPr>
          <p:cNvGrpSpPr/>
          <p:nvPr/>
        </p:nvGrpSpPr>
        <p:grpSpPr>
          <a:xfrm>
            <a:off x="7722372" y="330519"/>
            <a:ext cx="4144452" cy="3372743"/>
            <a:chOff x="7722372" y="330519"/>
            <a:chExt cx="3928797" cy="3372743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E2F6BFC-7C2B-44C6-93F9-B159F9D7FB8E}"/>
                </a:ext>
              </a:extLst>
            </p:cNvPr>
            <p:cNvSpPr txBox="1"/>
            <p:nvPr/>
          </p:nvSpPr>
          <p:spPr>
            <a:xfrm>
              <a:off x="8030734" y="330519"/>
              <a:ext cx="209977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1600" b="1"/>
                <a:t>C. Isoleucine </a:t>
              </a:r>
              <a:endParaRPr kumimoji="1" lang="ko-KR" altLang="en-US" sz="1600" b="1" dirty="0"/>
            </a:p>
          </p:txBody>
        </p:sp>
        <p:grpSp>
          <p:nvGrpSpPr>
            <p:cNvPr id="16" name="그룹 15">
              <a:extLst>
                <a:ext uri="{FF2B5EF4-FFF2-40B4-BE49-F238E27FC236}">
                  <a16:creationId xmlns:a16="http://schemas.microsoft.com/office/drawing/2014/main" id="{EE28B7F6-F024-4E3F-9A91-3365C950BDF6}"/>
                </a:ext>
              </a:extLst>
            </p:cNvPr>
            <p:cNvGrpSpPr/>
            <p:nvPr/>
          </p:nvGrpSpPr>
          <p:grpSpPr>
            <a:xfrm>
              <a:off x="7722372" y="428262"/>
              <a:ext cx="3928797" cy="3275000"/>
              <a:chOff x="7722372" y="428262"/>
              <a:chExt cx="3928797" cy="3275000"/>
            </a:xfrm>
          </p:grpSpPr>
          <p:pic>
            <p:nvPicPr>
              <p:cNvPr id="12" name="그림 11">
                <a:extLst>
                  <a:ext uri="{FF2B5EF4-FFF2-40B4-BE49-F238E27FC236}">
                    <a16:creationId xmlns:a16="http://schemas.microsoft.com/office/drawing/2014/main" id="{55961E47-862D-1A59-CB5F-70FBE0BD11E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7722372" y="428262"/>
                <a:ext cx="3928797" cy="3275000"/>
              </a:xfrm>
              <a:prstGeom prst="rect">
                <a:avLst/>
              </a:prstGeom>
            </p:spPr>
          </p:pic>
          <p:sp>
            <p:nvSpPr>
              <p:cNvPr id="14" name="직사각형 13">
                <a:extLst>
                  <a:ext uri="{FF2B5EF4-FFF2-40B4-BE49-F238E27FC236}">
                    <a16:creationId xmlns:a16="http://schemas.microsoft.com/office/drawing/2014/main" id="{9E631CD6-FF39-4860-B367-BDBF76191962}"/>
                  </a:ext>
                </a:extLst>
              </p:cNvPr>
              <p:cNvSpPr/>
              <p:nvPr/>
            </p:nvSpPr>
            <p:spPr>
              <a:xfrm>
                <a:off x="9433932" y="452741"/>
                <a:ext cx="814039" cy="2163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</p:grpSp>
      <p:grpSp>
        <p:nvGrpSpPr>
          <p:cNvPr id="25" name="그룹 24">
            <a:extLst>
              <a:ext uri="{FF2B5EF4-FFF2-40B4-BE49-F238E27FC236}">
                <a16:creationId xmlns:a16="http://schemas.microsoft.com/office/drawing/2014/main" id="{6B62E916-247E-479E-BFC8-5BF0FAC2215B}"/>
              </a:ext>
            </a:extLst>
          </p:cNvPr>
          <p:cNvGrpSpPr/>
          <p:nvPr/>
        </p:nvGrpSpPr>
        <p:grpSpPr>
          <a:xfrm>
            <a:off x="3415276" y="279719"/>
            <a:ext cx="4144452" cy="3469677"/>
            <a:chOff x="3336115" y="3508585"/>
            <a:chExt cx="4144452" cy="3469677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DBC57E9-73A3-4AFF-B110-AD608B61666F}"/>
                </a:ext>
              </a:extLst>
            </p:cNvPr>
            <p:cNvSpPr txBox="1"/>
            <p:nvPr/>
          </p:nvSpPr>
          <p:spPr>
            <a:xfrm>
              <a:off x="3625599" y="3508585"/>
              <a:ext cx="209977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1600" b="1"/>
                <a:t>B. Valine </a:t>
              </a:r>
              <a:endParaRPr kumimoji="1" lang="ko-KR" altLang="en-US" sz="1600" b="1" dirty="0"/>
            </a:p>
          </p:txBody>
        </p:sp>
        <p:grpSp>
          <p:nvGrpSpPr>
            <p:cNvPr id="19" name="그룹 18">
              <a:extLst>
                <a:ext uri="{FF2B5EF4-FFF2-40B4-BE49-F238E27FC236}">
                  <a16:creationId xmlns:a16="http://schemas.microsoft.com/office/drawing/2014/main" id="{DBA7934B-8321-4C82-AE47-3D00266D58FB}"/>
                </a:ext>
              </a:extLst>
            </p:cNvPr>
            <p:cNvGrpSpPr/>
            <p:nvPr/>
          </p:nvGrpSpPr>
          <p:grpSpPr>
            <a:xfrm>
              <a:off x="3336115" y="3703262"/>
              <a:ext cx="4144452" cy="3275000"/>
              <a:chOff x="3336115" y="3703262"/>
              <a:chExt cx="4144452" cy="3275000"/>
            </a:xfrm>
          </p:grpSpPr>
          <p:pic>
            <p:nvPicPr>
              <p:cNvPr id="22" name="그림 21">
                <a:extLst>
                  <a:ext uri="{FF2B5EF4-FFF2-40B4-BE49-F238E27FC236}">
                    <a16:creationId xmlns:a16="http://schemas.microsoft.com/office/drawing/2014/main" id="{2B4DE5A0-E693-5916-91FD-0855B874CF0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3336115" y="3703262"/>
                <a:ext cx="4144452" cy="3275000"/>
              </a:xfrm>
              <a:prstGeom prst="rect">
                <a:avLst/>
              </a:prstGeom>
            </p:spPr>
          </p:pic>
          <p:sp>
            <p:nvSpPr>
              <p:cNvPr id="18" name="직사각형 17">
                <a:extLst>
                  <a:ext uri="{FF2B5EF4-FFF2-40B4-BE49-F238E27FC236}">
                    <a16:creationId xmlns:a16="http://schemas.microsoft.com/office/drawing/2014/main" id="{0C770D19-D233-413B-9357-CCCBDDFF5E56}"/>
                  </a:ext>
                </a:extLst>
              </p:cNvPr>
              <p:cNvSpPr/>
              <p:nvPr/>
            </p:nvSpPr>
            <p:spPr>
              <a:xfrm>
                <a:off x="5247874" y="3749396"/>
                <a:ext cx="757731" cy="22043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</p:grpSp>
      <p:grpSp>
        <p:nvGrpSpPr>
          <p:cNvPr id="29" name="그룹 28">
            <a:extLst>
              <a:ext uri="{FF2B5EF4-FFF2-40B4-BE49-F238E27FC236}">
                <a16:creationId xmlns:a16="http://schemas.microsoft.com/office/drawing/2014/main" id="{9C6DEF19-6FCF-4687-A6AF-1E8158EC8DA1}"/>
              </a:ext>
            </a:extLst>
          </p:cNvPr>
          <p:cNvGrpSpPr/>
          <p:nvPr/>
        </p:nvGrpSpPr>
        <p:grpSpPr>
          <a:xfrm>
            <a:off x="7657617" y="3508585"/>
            <a:ext cx="4366668" cy="3469677"/>
            <a:chOff x="7657617" y="3508585"/>
            <a:chExt cx="4366668" cy="3469677"/>
          </a:xfrm>
        </p:grpSpPr>
        <p:grpSp>
          <p:nvGrpSpPr>
            <p:cNvPr id="28" name="그룹 27">
              <a:extLst>
                <a:ext uri="{FF2B5EF4-FFF2-40B4-BE49-F238E27FC236}">
                  <a16:creationId xmlns:a16="http://schemas.microsoft.com/office/drawing/2014/main" id="{F44EBA19-0FE3-4502-9441-FA2F2F2ED16A}"/>
                </a:ext>
              </a:extLst>
            </p:cNvPr>
            <p:cNvGrpSpPr/>
            <p:nvPr/>
          </p:nvGrpSpPr>
          <p:grpSpPr>
            <a:xfrm>
              <a:off x="7657617" y="3703262"/>
              <a:ext cx="4366668" cy="3275000"/>
              <a:chOff x="7657617" y="3703262"/>
              <a:chExt cx="4366668" cy="3275000"/>
            </a:xfrm>
          </p:grpSpPr>
          <p:pic>
            <p:nvPicPr>
              <p:cNvPr id="3" name="그림 2">
                <a:extLst>
                  <a:ext uri="{FF2B5EF4-FFF2-40B4-BE49-F238E27FC236}">
                    <a16:creationId xmlns:a16="http://schemas.microsoft.com/office/drawing/2014/main" id="{F275A684-DC85-A19A-A640-B1C86DF1A41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7657617" y="3703262"/>
                <a:ext cx="4366668" cy="3275000"/>
              </a:xfrm>
              <a:prstGeom prst="rect">
                <a:avLst/>
              </a:prstGeom>
            </p:spPr>
          </p:pic>
          <p:sp>
            <p:nvSpPr>
              <p:cNvPr id="27" name="직사각형 26">
                <a:extLst>
                  <a:ext uri="{FF2B5EF4-FFF2-40B4-BE49-F238E27FC236}">
                    <a16:creationId xmlns:a16="http://schemas.microsoft.com/office/drawing/2014/main" id="{4A0D0E1E-4198-449D-A467-7235AA4C07A3}"/>
                  </a:ext>
                </a:extLst>
              </p:cNvPr>
              <p:cNvSpPr/>
              <p:nvPr/>
            </p:nvSpPr>
            <p:spPr>
              <a:xfrm>
                <a:off x="9088244" y="3749396"/>
                <a:ext cx="1884556" cy="22043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45D73E5-9B5C-4FBA-B7F0-D596210EF7CA}"/>
                </a:ext>
              </a:extLst>
            </p:cNvPr>
            <p:cNvSpPr txBox="1"/>
            <p:nvPr/>
          </p:nvSpPr>
          <p:spPr>
            <a:xfrm>
              <a:off x="8036759" y="3508585"/>
              <a:ext cx="2700858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1600" b="1"/>
                <a:t>E. 2-Aminobutyric acid</a:t>
              </a:r>
              <a:endParaRPr kumimoji="1" lang="ko-KR" altLang="en-US" sz="16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5775588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BCCB571-6257-49FA-98F3-7E6447106D20}"/>
              </a:ext>
            </a:extLst>
          </p:cNvPr>
          <p:cNvSpPr txBox="1"/>
          <p:nvPr/>
        </p:nvSpPr>
        <p:spPr>
          <a:xfrm>
            <a:off x="75866" y="52631"/>
            <a:ext cx="57742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sz="2000" b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ko-KR" altLang="en-US" sz="20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S7A. </a:t>
            </a:r>
            <a:endParaRPr kumimoji="1" lang="ko-Kore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871FAEBD-CCB6-4EC1-B43B-057D7525380E}"/>
              </a:ext>
            </a:extLst>
          </p:cNvPr>
          <p:cNvGrpSpPr/>
          <p:nvPr/>
        </p:nvGrpSpPr>
        <p:grpSpPr>
          <a:xfrm>
            <a:off x="1394476" y="1170264"/>
            <a:ext cx="8185941" cy="4517471"/>
            <a:chOff x="500859" y="1675511"/>
            <a:chExt cx="5950348" cy="3570208"/>
          </a:xfrm>
        </p:grpSpPr>
        <p:pic>
          <p:nvPicPr>
            <p:cNvPr id="5" name="그래픽 4">
              <a:extLst>
                <a:ext uri="{FF2B5EF4-FFF2-40B4-BE49-F238E27FC236}">
                  <a16:creationId xmlns:a16="http://schemas.microsoft.com/office/drawing/2014/main" id="{8EF40E54-CD0C-43EA-88BC-B4BD7531C88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500859" y="1675511"/>
              <a:ext cx="2975174" cy="3570208"/>
            </a:xfrm>
            <a:prstGeom prst="rect">
              <a:avLst/>
            </a:prstGeom>
          </p:spPr>
        </p:pic>
        <p:pic>
          <p:nvPicPr>
            <p:cNvPr id="6" name="그래픽 5">
              <a:extLst>
                <a:ext uri="{FF2B5EF4-FFF2-40B4-BE49-F238E27FC236}">
                  <a16:creationId xmlns:a16="http://schemas.microsoft.com/office/drawing/2014/main" id="{71797278-4438-4830-B652-6A7123F593D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3476033" y="1675511"/>
              <a:ext cx="2975174" cy="3570208"/>
            </a:xfrm>
            <a:prstGeom prst="rect">
              <a:avLst/>
            </a:prstGeom>
          </p:spPr>
        </p:pic>
      </p:grpSp>
      <p:sp>
        <p:nvSpPr>
          <p:cNvPr id="2" name="직사각형 1">
            <a:extLst>
              <a:ext uri="{FF2B5EF4-FFF2-40B4-BE49-F238E27FC236}">
                <a16:creationId xmlns:a16="http://schemas.microsoft.com/office/drawing/2014/main" id="{B792CDE4-B6A1-4351-859E-86ADD2FD978E}"/>
              </a:ext>
            </a:extLst>
          </p:cNvPr>
          <p:cNvSpPr/>
          <p:nvPr/>
        </p:nvSpPr>
        <p:spPr>
          <a:xfrm>
            <a:off x="2202872" y="5382491"/>
            <a:ext cx="3429000" cy="4156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1400" b="1">
                <a:solidFill>
                  <a:schemeClr val="tx1"/>
                </a:solidFill>
              </a:rPr>
              <a:t>Dulaglutide_0M   Dulaglutide_12w </a:t>
            </a:r>
            <a:endParaRPr lang="ko-KR" altLang="en-US" sz="1400" b="1">
              <a:solidFill>
                <a:schemeClr val="tx1"/>
              </a:solidFill>
            </a:endParaRPr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005B2AC4-B176-4A94-915E-50F602BF2071}"/>
              </a:ext>
            </a:extLst>
          </p:cNvPr>
          <p:cNvSpPr/>
          <p:nvPr/>
        </p:nvSpPr>
        <p:spPr>
          <a:xfrm>
            <a:off x="6211668" y="5382491"/>
            <a:ext cx="3513175" cy="4156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1400" b="1">
                <a:solidFill>
                  <a:schemeClr val="tx1"/>
                </a:solidFill>
              </a:rPr>
              <a:t>Empagliflozin_0M   Empagliflozin_12w </a:t>
            </a:r>
            <a:endParaRPr lang="ko-KR" altLang="en-US" sz="1400" b="1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9954138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BCCB571-6257-49FA-98F3-7E6447106D20}"/>
              </a:ext>
            </a:extLst>
          </p:cNvPr>
          <p:cNvSpPr txBox="1"/>
          <p:nvPr/>
        </p:nvSpPr>
        <p:spPr>
          <a:xfrm>
            <a:off x="75866" y="52631"/>
            <a:ext cx="57742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sz="2000" b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ko-KR" altLang="en-US" sz="20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S7B. </a:t>
            </a:r>
            <a:endParaRPr kumimoji="1" lang="ko-Kore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7BEF4C2A-28AB-4EB3-BE98-27998BCA7047}"/>
              </a:ext>
            </a:extLst>
          </p:cNvPr>
          <p:cNvGrpSpPr/>
          <p:nvPr/>
        </p:nvGrpSpPr>
        <p:grpSpPr>
          <a:xfrm>
            <a:off x="144758" y="1358781"/>
            <a:ext cx="12047241" cy="4712370"/>
            <a:chOff x="144758" y="1358781"/>
            <a:chExt cx="12047241" cy="4712370"/>
          </a:xfrm>
        </p:grpSpPr>
        <p:pic>
          <p:nvPicPr>
            <p:cNvPr id="8" name="그래픽 7">
              <a:extLst>
                <a:ext uri="{FF2B5EF4-FFF2-40B4-BE49-F238E27FC236}">
                  <a16:creationId xmlns:a16="http://schemas.microsoft.com/office/drawing/2014/main" id="{026CC012-05BC-4ECD-AC5D-8C5FB65A504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144758" y="1358782"/>
              <a:ext cx="5890461" cy="4712369"/>
            </a:xfrm>
            <a:prstGeom prst="rect">
              <a:avLst/>
            </a:prstGeom>
          </p:spPr>
        </p:pic>
        <p:pic>
          <p:nvPicPr>
            <p:cNvPr id="9" name="그래픽 8">
              <a:extLst>
                <a:ext uri="{FF2B5EF4-FFF2-40B4-BE49-F238E27FC236}">
                  <a16:creationId xmlns:a16="http://schemas.microsoft.com/office/drawing/2014/main" id="{23FC499C-95D6-4B63-80C8-CCFB12053F4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6301537" y="1358781"/>
              <a:ext cx="5890462" cy="4712370"/>
            </a:xfrm>
            <a:prstGeom prst="rect">
              <a:avLst/>
            </a:prstGeom>
          </p:spPr>
        </p:pic>
      </p:grpSp>
      <p:sp>
        <p:nvSpPr>
          <p:cNvPr id="3" name="직사각형 2">
            <a:extLst>
              <a:ext uri="{FF2B5EF4-FFF2-40B4-BE49-F238E27FC236}">
                <a16:creationId xmlns:a16="http://schemas.microsoft.com/office/drawing/2014/main" id="{271E3161-CE1F-4619-A9F0-FA181AD3D40B}"/>
              </a:ext>
            </a:extLst>
          </p:cNvPr>
          <p:cNvSpPr/>
          <p:nvPr/>
        </p:nvSpPr>
        <p:spPr>
          <a:xfrm>
            <a:off x="5107301" y="3347857"/>
            <a:ext cx="1049482" cy="7342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12" name="그룹 11">
            <a:extLst>
              <a:ext uri="{FF2B5EF4-FFF2-40B4-BE49-F238E27FC236}">
                <a16:creationId xmlns:a16="http://schemas.microsoft.com/office/drawing/2014/main" id="{E3AF431D-F8CB-4F1B-9135-E3CDEEA4FA61}"/>
              </a:ext>
            </a:extLst>
          </p:cNvPr>
          <p:cNvGrpSpPr/>
          <p:nvPr/>
        </p:nvGrpSpPr>
        <p:grpSpPr>
          <a:xfrm>
            <a:off x="706582" y="6053228"/>
            <a:ext cx="4001547" cy="277000"/>
            <a:chOff x="706582" y="6053228"/>
            <a:chExt cx="4001547" cy="277000"/>
          </a:xfrm>
        </p:grpSpPr>
        <p:sp>
          <p:nvSpPr>
            <p:cNvPr id="6" name="순서도: 연결자 5">
              <a:extLst>
                <a:ext uri="{FF2B5EF4-FFF2-40B4-BE49-F238E27FC236}">
                  <a16:creationId xmlns:a16="http://schemas.microsoft.com/office/drawing/2014/main" id="{30FA12F8-B5E2-4242-8008-FA61B1058091}"/>
                </a:ext>
              </a:extLst>
            </p:cNvPr>
            <p:cNvSpPr/>
            <p:nvPr/>
          </p:nvSpPr>
          <p:spPr>
            <a:xfrm>
              <a:off x="706582" y="6113882"/>
              <a:ext cx="135082" cy="135081"/>
            </a:xfrm>
            <a:prstGeom prst="flowChartConnector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" name="순서도: 연결자 9">
              <a:extLst>
                <a:ext uri="{FF2B5EF4-FFF2-40B4-BE49-F238E27FC236}">
                  <a16:creationId xmlns:a16="http://schemas.microsoft.com/office/drawing/2014/main" id="{0D56413B-1736-40CB-93FC-2B27C2EE3A19}"/>
                </a:ext>
              </a:extLst>
            </p:cNvPr>
            <p:cNvSpPr/>
            <p:nvPr/>
          </p:nvSpPr>
          <p:spPr>
            <a:xfrm>
              <a:off x="3150892" y="6113882"/>
              <a:ext cx="135082" cy="135081"/>
            </a:xfrm>
            <a:prstGeom prst="flowChartConnector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B2709B2-AEC5-4104-9E7F-21D1432DE10A}"/>
                </a:ext>
              </a:extLst>
            </p:cNvPr>
            <p:cNvSpPr txBox="1"/>
            <p:nvPr/>
          </p:nvSpPr>
          <p:spPr>
            <a:xfrm>
              <a:off x="896726" y="6053228"/>
              <a:ext cx="13923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/>
                <a:t>Dulaglutide_0M </a:t>
              </a:r>
              <a:endParaRPr lang="ko-KR" altLang="en-US" sz="1200" b="1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F319B15-2853-4C0A-B8D1-C4A5E4B2A9FC}"/>
                </a:ext>
              </a:extLst>
            </p:cNvPr>
            <p:cNvSpPr txBox="1"/>
            <p:nvPr/>
          </p:nvSpPr>
          <p:spPr>
            <a:xfrm>
              <a:off x="3315748" y="6053229"/>
              <a:ext cx="13923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/>
                <a:t>Dulaglutide_3M </a:t>
              </a:r>
              <a:endParaRPr lang="ko-KR" altLang="en-US" sz="1200" b="1"/>
            </a:p>
          </p:txBody>
        </p:sp>
      </p:grpSp>
      <p:grpSp>
        <p:nvGrpSpPr>
          <p:cNvPr id="13" name="그룹 12">
            <a:extLst>
              <a:ext uri="{FF2B5EF4-FFF2-40B4-BE49-F238E27FC236}">
                <a16:creationId xmlns:a16="http://schemas.microsoft.com/office/drawing/2014/main" id="{E822B074-AD5E-4182-BCA8-E6FA877ACDB5}"/>
              </a:ext>
            </a:extLst>
          </p:cNvPr>
          <p:cNvGrpSpPr/>
          <p:nvPr/>
        </p:nvGrpSpPr>
        <p:grpSpPr>
          <a:xfrm>
            <a:off x="7061860" y="6053227"/>
            <a:ext cx="4137480" cy="277000"/>
            <a:chOff x="706582" y="6053228"/>
            <a:chExt cx="4137480" cy="277000"/>
          </a:xfrm>
        </p:grpSpPr>
        <p:sp>
          <p:nvSpPr>
            <p:cNvPr id="14" name="순서도: 연결자 13">
              <a:extLst>
                <a:ext uri="{FF2B5EF4-FFF2-40B4-BE49-F238E27FC236}">
                  <a16:creationId xmlns:a16="http://schemas.microsoft.com/office/drawing/2014/main" id="{44E06554-DEC3-41E7-AAE2-DC679B3A9DC7}"/>
                </a:ext>
              </a:extLst>
            </p:cNvPr>
            <p:cNvSpPr/>
            <p:nvPr/>
          </p:nvSpPr>
          <p:spPr>
            <a:xfrm>
              <a:off x="706582" y="6113882"/>
              <a:ext cx="135082" cy="135081"/>
            </a:xfrm>
            <a:prstGeom prst="flowChartConnector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" name="순서도: 연결자 14">
              <a:extLst>
                <a:ext uri="{FF2B5EF4-FFF2-40B4-BE49-F238E27FC236}">
                  <a16:creationId xmlns:a16="http://schemas.microsoft.com/office/drawing/2014/main" id="{5DC7A437-9711-4FEC-A59B-ED38C073ABC9}"/>
                </a:ext>
              </a:extLst>
            </p:cNvPr>
            <p:cNvSpPr/>
            <p:nvPr/>
          </p:nvSpPr>
          <p:spPr>
            <a:xfrm>
              <a:off x="3150892" y="6113882"/>
              <a:ext cx="135082" cy="135081"/>
            </a:xfrm>
            <a:prstGeom prst="flowChartConnector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BFE5E29-D5AE-4D24-8203-79254F0F9DCC}"/>
                </a:ext>
              </a:extLst>
            </p:cNvPr>
            <p:cNvSpPr txBox="1"/>
            <p:nvPr/>
          </p:nvSpPr>
          <p:spPr>
            <a:xfrm>
              <a:off x="896726" y="6053228"/>
              <a:ext cx="15283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/>
                <a:t>Empagliflozin_0M </a:t>
              </a:r>
              <a:endParaRPr lang="ko-KR" altLang="en-US" sz="1200" b="1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8B84D9A-6B0D-4D82-BB64-55F112DE0A03}"/>
                </a:ext>
              </a:extLst>
            </p:cNvPr>
            <p:cNvSpPr txBox="1"/>
            <p:nvPr/>
          </p:nvSpPr>
          <p:spPr>
            <a:xfrm>
              <a:off x="3315748" y="6053229"/>
              <a:ext cx="15283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/>
                <a:t>Empagliflozin_3M </a:t>
              </a:r>
              <a:endParaRPr lang="ko-KR" altLang="en-US" sz="1200" b="1"/>
            </a:p>
          </p:txBody>
        </p:sp>
      </p:grp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A7A17CB5-C989-4E12-A903-4E8C836416F8}"/>
              </a:ext>
            </a:extLst>
          </p:cNvPr>
          <p:cNvSpPr/>
          <p:nvPr/>
        </p:nvSpPr>
        <p:spPr>
          <a:xfrm>
            <a:off x="11199340" y="3344891"/>
            <a:ext cx="992659" cy="7342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82904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9</TotalTime>
  <Words>560</Words>
  <Application>Microsoft Office PowerPoint</Application>
  <PresentationFormat>와이드스크린</PresentationFormat>
  <Paragraphs>263</Paragraphs>
  <Slides>9</Slides>
  <Notes>5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3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i eun Jun</dc:creator>
  <cp:lastModifiedBy>Ji eun Jun</cp:lastModifiedBy>
  <cp:revision>37</cp:revision>
  <dcterms:created xsi:type="dcterms:W3CDTF">2025-01-01T09:39:07Z</dcterms:created>
  <dcterms:modified xsi:type="dcterms:W3CDTF">2025-12-28T05:20:02Z</dcterms:modified>
</cp:coreProperties>
</file>